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1" r:id="rId2"/>
    <p:sldId id="265" r:id="rId3"/>
    <p:sldId id="261" r:id="rId4"/>
    <p:sldId id="263" r:id="rId5"/>
  </p:sldIdLst>
  <p:sldSz cx="12192000" cy="6858000"/>
  <p:notesSz cx="6735763" cy="9866313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0B26532-D99B-048B-6AEF-BE2D67B8116F}" name="Borlaug, Barry A., M.D." initials="BB" userId="S::Borlaug.Barry@mayo.edu::a3dd1d26-22a3-4dad-a1f9-d630099fa70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32" y="8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cs-C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41689004785001"/>
          <c:y val="4.1197899602247949E-2"/>
          <c:w val="0.82372353439307755"/>
          <c:h val="0.84262402351941279"/>
        </c:manualLayout>
      </c:layout>
      <c:scatterChart>
        <c:scatterStyle val="lineMarker"/>
        <c:varyColors val="0"/>
        <c:ser>
          <c:idx val="0"/>
          <c:order val="0"/>
          <c:tx>
            <c:v>up-regulated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xVal>
            <c:numRef>
              <c:f>'HFvsCTRL-K1volcano'!$C$2:$C$34</c:f>
              <c:numCache>
                <c:formatCode>General</c:formatCode>
                <c:ptCount val="33"/>
                <c:pt idx="0">
                  <c:v>5.1054161190476188</c:v>
                </c:pt>
                <c:pt idx="1">
                  <c:v>5.6232473511904759</c:v>
                </c:pt>
                <c:pt idx="2">
                  <c:v>2.0884466845238121</c:v>
                </c:pt>
                <c:pt idx="3">
                  <c:v>2.6736127619047618</c:v>
                </c:pt>
                <c:pt idx="4">
                  <c:v>3.1812327202380959</c:v>
                </c:pt>
                <c:pt idx="5">
                  <c:v>1.5938584166666683</c:v>
                </c:pt>
                <c:pt idx="6">
                  <c:v>1.468632845238095</c:v>
                </c:pt>
                <c:pt idx="7">
                  <c:v>1.1615701130952338</c:v>
                </c:pt>
                <c:pt idx="8">
                  <c:v>1.229691107142858</c:v>
                </c:pt>
                <c:pt idx="9">
                  <c:v>1.1032979404761871</c:v>
                </c:pt>
                <c:pt idx="10">
                  <c:v>1.0197398750000017</c:v>
                </c:pt>
                <c:pt idx="11">
                  <c:v>1.9864496904761921</c:v>
                </c:pt>
                <c:pt idx="12">
                  <c:v>1.0614883095238081</c:v>
                </c:pt>
                <c:pt idx="13">
                  <c:v>1.615906726190476</c:v>
                </c:pt>
                <c:pt idx="14">
                  <c:v>1.8399205178571441</c:v>
                </c:pt>
                <c:pt idx="15">
                  <c:v>1.2214892559523811</c:v>
                </c:pt>
                <c:pt idx="16">
                  <c:v>2.3174057797619056</c:v>
                </c:pt>
                <c:pt idx="17">
                  <c:v>1.0082000119047603</c:v>
                </c:pt>
                <c:pt idx="18">
                  <c:v>1.2364507380952388</c:v>
                </c:pt>
                <c:pt idx="19">
                  <c:v>1.0899282440476208</c:v>
                </c:pt>
                <c:pt idx="20">
                  <c:v>1.0216177619047615</c:v>
                </c:pt>
                <c:pt idx="21">
                  <c:v>1.0212601845238103</c:v>
                </c:pt>
                <c:pt idx="22">
                  <c:v>1.2924309642857148</c:v>
                </c:pt>
                <c:pt idx="23">
                  <c:v>1.1187406071428594</c:v>
                </c:pt>
                <c:pt idx="24">
                  <c:v>2.1019030892857193</c:v>
                </c:pt>
                <c:pt idx="25">
                  <c:v>1.9285746785714277</c:v>
                </c:pt>
                <c:pt idx="26">
                  <c:v>1.5947906547619022</c:v>
                </c:pt>
                <c:pt idx="27">
                  <c:v>1.0004286071428545</c:v>
                </c:pt>
                <c:pt idx="28">
                  <c:v>1.090845416666669</c:v>
                </c:pt>
                <c:pt idx="29">
                  <c:v>1.2863287678571442</c:v>
                </c:pt>
                <c:pt idx="30">
                  <c:v>1.0177457261904772</c:v>
                </c:pt>
                <c:pt idx="31">
                  <c:v>1.0913078988095233</c:v>
                </c:pt>
                <c:pt idx="32">
                  <c:v>1.0507396369047601</c:v>
                </c:pt>
              </c:numCache>
            </c:numRef>
          </c:xVal>
          <c:yVal>
            <c:numRef>
              <c:f>'HFvsCTRL-K1volcano'!$H$2:$H$34</c:f>
              <c:numCache>
                <c:formatCode>General</c:formatCode>
                <c:ptCount val="33"/>
                <c:pt idx="0">
                  <c:v>19.802144578460364</c:v>
                </c:pt>
                <c:pt idx="1">
                  <c:v>16.127893835374103</c:v>
                </c:pt>
                <c:pt idx="2">
                  <c:v>15.622172313093735</c:v>
                </c:pt>
                <c:pt idx="3">
                  <c:v>15.114763027178476</c:v>
                </c:pt>
                <c:pt idx="4">
                  <c:v>14.472514541645308</c:v>
                </c:pt>
                <c:pt idx="5">
                  <c:v>13.243547691934323</c:v>
                </c:pt>
                <c:pt idx="6">
                  <c:v>12.191703264722774</c:v>
                </c:pt>
                <c:pt idx="7">
                  <c:v>11.820172624379227</c:v>
                </c:pt>
                <c:pt idx="8">
                  <c:v>11.12201433248957</c:v>
                </c:pt>
                <c:pt idx="9">
                  <c:v>11.01473277525635</c:v>
                </c:pt>
                <c:pt idx="10">
                  <c:v>10.623634753031961</c:v>
                </c:pt>
                <c:pt idx="11">
                  <c:v>10.554676308560509</c:v>
                </c:pt>
                <c:pt idx="12">
                  <c:v>10.486972876613024</c:v>
                </c:pt>
                <c:pt idx="13">
                  <c:v>10.201430285276968</c:v>
                </c:pt>
                <c:pt idx="14">
                  <c:v>10.123985812951425</c:v>
                </c:pt>
                <c:pt idx="15">
                  <c:v>10.072363645640539</c:v>
                </c:pt>
                <c:pt idx="16">
                  <c:v>9.3483688669636518</c:v>
                </c:pt>
                <c:pt idx="17">
                  <c:v>9.1455892421923703</c:v>
                </c:pt>
                <c:pt idx="18">
                  <c:v>8.5070001994358702</c:v>
                </c:pt>
                <c:pt idx="19">
                  <c:v>8.3450581552480436</c:v>
                </c:pt>
                <c:pt idx="20">
                  <c:v>7.7329672835611962</c:v>
                </c:pt>
                <c:pt idx="21">
                  <c:v>6.8533544912854616</c:v>
                </c:pt>
                <c:pt idx="22">
                  <c:v>6.7774807164326623</c:v>
                </c:pt>
                <c:pt idx="23">
                  <c:v>6.3502372842851118</c:v>
                </c:pt>
                <c:pt idx="24">
                  <c:v>5.368506043524004</c:v>
                </c:pt>
                <c:pt idx="25">
                  <c:v>5.1084471881057256</c:v>
                </c:pt>
                <c:pt idx="26">
                  <c:v>5.0978735070677121</c:v>
                </c:pt>
                <c:pt idx="27">
                  <c:v>5.0214026205642543</c:v>
                </c:pt>
                <c:pt idx="28">
                  <c:v>4.8524401529518073</c:v>
                </c:pt>
                <c:pt idx="29">
                  <c:v>4.8364954615537936</c:v>
                </c:pt>
                <c:pt idx="30">
                  <c:v>3.4249894446473097</c:v>
                </c:pt>
                <c:pt idx="31">
                  <c:v>3.3377121774654368</c:v>
                </c:pt>
                <c:pt idx="32">
                  <c:v>2.486207001654985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697-4DA2-B756-9F712B98FADE}"/>
            </c:ext>
          </c:extLst>
        </c:ser>
        <c:ser>
          <c:idx val="1"/>
          <c:order val="1"/>
          <c:tx>
            <c:v>down-regulated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noFill/>
              </a:ln>
              <a:effectLst/>
            </c:spPr>
          </c:marker>
          <c:xVal>
            <c:numRef>
              <c:f>'HFvsCTRL-K1volcano'!$C$35:$C$39</c:f>
              <c:numCache>
                <c:formatCode>General</c:formatCode>
                <c:ptCount val="5"/>
                <c:pt idx="0">
                  <c:v>-1.0877329285714268</c:v>
                </c:pt>
                <c:pt idx="1">
                  <c:v>-2.1195952321428617</c:v>
                </c:pt>
                <c:pt idx="2">
                  <c:v>-1.4646083928571412</c:v>
                </c:pt>
                <c:pt idx="3">
                  <c:v>-1.7622772261904762</c:v>
                </c:pt>
                <c:pt idx="4">
                  <c:v>-1.1684322202380955</c:v>
                </c:pt>
              </c:numCache>
            </c:numRef>
          </c:xVal>
          <c:yVal>
            <c:numRef>
              <c:f>'HFvsCTRL-K1volcano'!$H$35:$H$39</c:f>
              <c:numCache>
                <c:formatCode>General</c:formatCode>
                <c:ptCount val="5"/>
                <c:pt idx="0">
                  <c:v>8.3428198722160065</c:v>
                </c:pt>
                <c:pt idx="1">
                  <c:v>3.7829226848495425</c:v>
                </c:pt>
                <c:pt idx="2">
                  <c:v>2.377713022182538</c:v>
                </c:pt>
                <c:pt idx="3">
                  <c:v>2.2989459461840149</c:v>
                </c:pt>
                <c:pt idx="4">
                  <c:v>1.78199783674158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697-4DA2-B756-9F712B98FADE}"/>
            </c:ext>
          </c:extLst>
        </c:ser>
        <c:ser>
          <c:idx val="2"/>
          <c:order val="2"/>
          <c:tx>
            <c:v>other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2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HFvsCTRL-K1volcano'!$C$40:$C$277</c:f>
              <c:numCache>
                <c:formatCode>General</c:formatCode>
                <c:ptCount val="238"/>
                <c:pt idx="0">
                  <c:v>0.82002088690476072</c:v>
                </c:pt>
                <c:pt idx="1">
                  <c:v>0.89180652380952319</c:v>
                </c:pt>
                <c:pt idx="2">
                  <c:v>0.43160201190476144</c:v>
                </c:pt>
                <c:pt idx="3">
                  <c:v>0.86197825000000527</c:v>
                </c:pt>
                <c:pt idx="4">
                  <c:v>0.76048888690476169</c:v>
                </c:pt>
                <c:pt idx="5">
                  <c:v>0.97226659523809467</c:v>
                </c:pt>
                <c:pt idx="6">
                  <c:v>0.7180174107142836</c:v>
                </c:pt>
                <c:pt idx="7">
                  <c:v>0.76208638095238168</c:v>
                </c:pt>
                <c:pt idx="8">
                  <c:v>0.44903038690476027</c:v>
                </c:pt>
                <c:pt idx="9">
                  <c:v>0.80126199999999947</c:v>
                </c:pt>
                <c:pt idx="10">
                  <c:v>0.55022009523809245</c:v>
                </c:pt>
                <c:pt idx="11">
                  <c:v>0.74980963095237962</c:v>
                </c:pt>
                <c:pt idx="12">
                  <c:v>0.40309230357142845</c:v>
                </c:pt>
                <c:pt idx="13">
                  <c:v>0.65242617857142537</c:v>
                </c:pt>
                <c:pt idx="14">
                  <c:v>0.77215354761904731</c:v>
                </c:pt>
                <c:pt idx="15">
                  <c:v>0.80097927976190597</c:v>
                </c:pt>
                <c:pt idx="16">
                  <c:v>0.64478764285713908</c:v>
                </c:pt>
                <c:pt idx="17">
                  <c:v>0.73009470833333356</c:v>
                </c:pt>
                <c:pt idx="18">
                  <c:v>0.61845341666666709</c:v>
                </c:pt>
                <c:pt idx="19">
                  <c:v>0.75090716071428609</c:v>
                </c:pt>
                <c:pt idx="20">
                  <c:v>0.879628351190477</c:v>
                </c:pt>
                <c:pt idx="21">
                  <c:v>0.49695826190476033</c:v>
                </c:pt>
                <c:pt idx="22">
                  <c:v>0.64996774404761748</c:v>
                </c:pt>
                <c:pt idx="23">
                  <c:v>0.66975704761904797</c:v>
                </c:pt>
                <c:pt idx="24">
                  <c:v>0.7209088154761929</c:v>
                </c:pt>
                <c:pt idx="25">
                  <c:v>0.5430368273809556</c:v>
                </c:pt>
                <c:pt idx="26">
                  <c:v>0.63160709523809189</c:v>
                </c:pt>
                <c:pt idx="27">
                  <c:v>0.31737167261904453</c:v>
                </c:pt>
                <c:pt idx="28">
                  <c:v>0.83655910714285797</c:v>
                </c:pt>
                <c:pt idx="29">
                  <c:v>0.69909306547619021</c:v>
                </c:pt>
                <c:pt idx="30">
                  <c:v>0.61121626190476164</c:v>
                </c:pt>
                <c:pt idx="31">
                  <c:v>0.51982257142857069</c:v>
                </c:pt>
                <c:pt idx="32">
                  <c:v>0.79293973809523877</c:v>
                </c:pt>
                <c:pt idx="33">
                  <c:v>0.59115166666666585</c:v>
                </c:pt>
                <c:pt idx="34">
                  <c:v>0.49078111904761723</c:v>
                </c:pt>
                <c:pt idx="35">
                  <c:v>0.90909173214285932</c:v>
                </c:pt>
                <c:pt idx="36">
                  <c:v>-0.77353122619047099</c:v>
                </c:pt>
                <c:pt idx="37">
                  <c:v>0.94026459523809613</c:v>
                </c:pt>
                <c:pt idx="38">
                  <c:v>0.64762343452380877</c:v>
                </c:pt>
                <c:pt idx="39">
                  <c:v>0.44728843452381106</c:v>
                </c:pt>
                <c:pt idx="40">
                  <c:v>0.54694921428571508</c:v>
                </c:pt>
                <c:pt idx="41">
                  <c:v>0.65784593452380946</c:v>
                </c:pt>
                <c:pt idx="42">
                  <c:v>0.93421680357142822</c:v>
                </c:pt>
                <c:pt idx="43">
                  <c:v>0.30743294047619241</c:v>
                </c:pt>
                <c:pt idx="44">
                  <c:v>0.82521016071428699</c:v>
                </c:pt>
                <c:pt idx="45">
                  <c:v>0.99998368452381303</c:v>
                </c:pt>
                <c:pt idx="46">
                  <c:v>0.41948524999999748</c:v>
                </c:pt>
                <c:pt idx="47">
                  <c:v>0.70545749404762059</c:v>
                </c:pt>
                <c:pt idx="48">
                  <c:v>0.48730705952380893</c:v>
                </c:pt>
                <c:pt idx="49">
                  <c:v>0.59407952380952445</c:v>
                </c:pt>
                <c:pt idx="50">
                  <c:v>0.60081657738095284</c:v>
                </c:pt>
                <c:pt idx="51">
                  <c:v>0.4155924166666658</c:v>
                </c:pt>
                <c:pt idx="52">
                  <c:v>0.27067939880951997</c:v>
                </c:pt>
                <c:pt idx="53">
                  <c:v>0.75150683928571294</c:v>
                </c:pt>
                <c:pt idx="54">
                  <c:v>0.92074822023809455</c:v>
                </c:pt>
                <c:pt idx="55">
                  <c:v>0.43123144047618744</c:v>
                </c:pt>
                <c:pt idx="56">
                  <c:v>-0.73477782738095065</c:v>
                </c:pt>
                <c:pt idx="57">
                  <c:v>0.44573302976190421</c:v>
                </c:pt>
                <c:pt idx="58">
                  <c:v>0.45018508333333307</c:v>
                </c:pt>
                <c:pt idx="59">
                  <c:v>0.35089181547619308</c:v>
                </c:pt>
                <c:pt idx="60">
                  <c:v>0.64600138690476161</c:v>
                </c:pt>
                <c:pt idx="61">
                  <c:v>0.87604180952381139</c:v>
                </c:pt>
                <c:pt idx="62">
                  <c:v>0.38648576190475481</c:v>
                </c:pt>
                <c:pt idx="63">
                  <c:v>0.75375175595238098</c:v>
                </c:pt>
                <c:pt idx="64">
                  <c:v>0.7440875238095237</c:v>
                </c:pt>
                <c:pt idx="65">
                  <c:v>0.49129936904761706</c:v>
                </c:pt>
                <c:pt idx="66">
                  <c:v>0.7026251190476196</c:v>
                </c:pt>
                <c:pt idx="67">
                  <c:v>0.53571025595238186</c:v>
                </c:pt>
                <c:pt idx="68">
                  <c:v>0.76434776190476494</c:v>
                </c:pt>
                <c:pt idx="69">
                  <c:v>0.31464143452381066</c:v>
                </c:pt>
                <c:pt idx="70">
                  <c:v>0.37316990476190171</c:v>
                </c:pt>
                <c:pt idx="71">
                  <c:v>0.64861909523810368</c:v>
                </c:pt>
                <c:pt idx="72">
                  <c:v>0.35078573214285846</c:v>
                </c:pt>
                <c:pt idx="73">
                  <c:v>0.66099214880952406</c:v>
                </c:pt>
                <c:pt idx="74">
                  <c:v>0.46919752976190354</c:v>
                </c:pt>
                <c:pt idx="75">
                  <c:v>0.53839019642856911</c:v>
                </c:pt>
                <c:pt idx="76">
                  <c:v>0.97800197023809332</c:v>
                </c:pt>
                <c:pt idx="77">
                  <c:v>0.6481799404761901</c:v>
                </c:pt>
                <c:pt idx="78">
                  <c:v>0.41396289285714438</c:v>
                </c:pt>
                <c:pt idx="79">
                  <c:v>-0.46053691666666641</c:v>
                </c:pt>
                <c:pt idx="80">
                  <c:v>0.25854035119047403</c:v>
                </c:pt>
                <c:pt idx="81">
                  <c:v>0.57372857738095107</c:v>
                </c:pt>
                <c:pt idx="82">
                  <c:v>0.55413814285714214</c:v>
                </c:pt>
                <c:pt idx="83">
                  <c:v>0.2978066904761878</c:v>
                </c:pt>
                <c:pt idx="84">
                  <c:v>0.90156953571428389</c:v>
                </c:pt>
                <c:pt idx="85">
                  <c:v>0.49196061904761912</c:v>
                </c:pt>
                <c:pt idx="86">
                  <c:v>0.29568618452381035</c:v>
                </c:pt>
                <c:pt idx="87">
                  <c:v>0.75381046428571086</c:v>
                </c:pt>
                <c:pt idx="88">
                  <c:v>0.38690765476190592</c:v>
                </c:pt>
                <c:pt idx="89">
                  <c:v>0.39492370833333013</c:v>
                </c:pt>
                <c:pt idx="90">
                  <c:v>0.64355254761904934</c:v>
                </c:pt>
                <c:pt idx="91">
                  <c:v>0.44159633928571429</c:v>
                </c:pt>
                <c:pt idx="92">
                  <c:v>0.58273667857142719</c:v>
                </c:pt>
                <c:pt idx="93">
                  <c:v>0.29588908333332498</c:v>
                </c:pt>
                <c:pt idx="94">
                  <c:v>0.63361633333333334</c:v>
                </c:pt>
                <c:pt idx="95">
                  <c:v>0.32095836904761832</c:v>
                </c:pt>
                <c:pt idx="96">
                  <c:v>0.93809510119047701</c:v>
                </c:pt>
                <c:pt idx="97">
                  <c:v>0.57870113095238196</c:v>
                </c:pt>
                <c:pt idx="98">
                  <c:v>0.28497755357143184</c:v>
                </c:pt>
                <c:pt idx="99">
                  <c:v>0.45259567857143068</c:v>
                </c:pt>
                <c:pt idx="100">
                  <c:v>0.3730170654761924</c:v>
                </c:pt>
                <c:pt idx="101">
                  <c:v>0.84419580952380979</c:v>
                </c:pt>
                <c:pt idx="102">
                  <c:v>-0.39172769047619127</c:v>
                </c:pt>
                <c:pt idx="103">
                  <c:v>0.47284635714286338</c:v>
                </c:pt>
                <c:pt idx="104">
                  <c:v>0.65590414285714083</c:v>
                </c:pt>
                <c:pt idx="105">
                  <c:v>0.30614643452380896</c:v>
                </c:pt>
                <c:pt idx="106">
                  <c:v>0.4940716369047613</c:v>
                </c:pt>
                <c:pt idx="107">
                  <c:v>-0.44227922619047622</c:v>
                </c:pt>
                <c:pt idx="108">
                  <c:v>0.29133047619047581</c:v>
                </c:pt>
                <c:pt idx="109">
                  <c:v>0.47079588690476193</c:v>
                </c:pt>
                <c:pt idx="110">
                  <c:v>0.57787380357143192</c:v>
                </c:pt>
                <c:pt idx="111">
                  <c:v>0.52453310119047369</c:v>
                </c:pt>
                <c:pt idx="112">
                  <c:v>0.29911078571428806</c:v>
                </c:pt>
                <c:pt idx="113">
                  <c:v>0.35355427976190335</c:v>
                </c:pt>
                <c:pt idx="114">
                  <c:v>0.14528563690476393</c:v>
                </c:pt>
                <c:pt idx="115">
                  <c:v>0.2688781845238104</c:v>
                </c:pt>
                <c:pt idx="116">
                  <c:v>0.41770404761904789</c:v>
                </c:pt>
                <c:pt idx="117">
                  <c:v>0.24420873214285699</c:v>
                </c:pt>
                <c:pt idx="118">
                  <c:v>-0.89057139285714271</c:v>
                </c:pt>
                <c:pt idx="119">
                  <c:v>-0.83235752380952399</c:v>
                </c:pt>
                <c:pt idx="120">
                  <c:v>0.51034692261904757</c:v>
                </c:pt>
                <c:pt idx="121">
                  <c:v>-0.70243117261904153</c:v>
                </c:pt>
                <c:pt idx="122">
                  <c:v>0.5210933035714298</c:v>
                </c:pt>
                <c:pt idx="123">
                  <c:v>0.38646934523809495</c:v>
                </c:pt>
                <c:pt idx="124">
                  <c:v>0.29349154166666658</c:v>
                </c:pt>
                <c:pt idx="125">
                  <c:v>0.28328437500000092</c:v>
                </c:pt>
                <c:pt idx="126">
                  <c:v>0.25747737500000001</c:v>
                </c:pt>
                <c:pt idx="127">
                  <c:v>-0.95502377976190389</c:v>
                </c:pt>
                <c:pt idx="128">
                  <c:v>0.53621407738095428</c:v>
                </c:pt>
                <c:pt idx="129">
                  <c:v>0.70868154166667008</c:v>
                </c:pt>
                <c:pt idx="130">
                  <c:v>0.80512997619047777</c:v>
                </c:pt>
                <c:pt idx="131">
                  <c:v>-0.61788961309523849</c:v>
                </c:pt>
                <c:pt idx="132">
                  <c:v>-0.37619624404762142</c:v>
                </c:pt>
                <c:pt idx="133">
                  <c:v>0.1746147738095285</c:v>
                </c:pt>
                <c:pt idx="134">
                  <c:v>-0.20049072619047159</c:v>
                </c:pt>
                <c:pt idx="135">
                  <c:v>0.38078801785714234</c:v>
                </c:pt>
                <c:pt idx="136">
                  <c:v>0.19851175595238102</c:v>
                </c:pt>
                <c:pt idx="137">
                  <c:v>0.4062010476190494</c:v>
                </c:pt>
                <c:pt idx="138">
                  <c:v>0.41100204166666732</c:v>
                </c:pt>
                <c:pt idx="139">
                  <c:v>0.24091369047619052</c:v>
                </c:pt>
                <c:pt idx="140">
                  <c:v>-0.81382898809523585</c:v>
                </c:pt>
                <c:pt idx="141">
                  <c:v>0.21822164285714329</c:v>
                </c:pt>
                <c:pt idx="142">
                  <c:v>0.35434450595238065</c:v>
                </c:pt>
                <c:pt idx="143">
                  <c:v>0.44538676190476512</c:v>
                </c:pt>
                <c:pt idx="144">
                  <c:v>0.48789561309524032</c:v>
                </c:pt>
                <c:pt idx="145">
                  <c:v>0.34783883928571768</c:v>
                </c:pt>
                <c:pt idx="146">
                  <c:v>0.51025653571428187</c:v>
                </c:pt>
                <c:pt idx="147">
                  <c:v>0.26248101785714439</c:v>
                </c:pt>
                <c:pt idx="148">
                  <c:v>0.2481883690476181</c:v>
                </c:pt>
                <c:pt idx="149">
                  <c:v>0.33594679166666808</c:v>
                </c:pt>
                <c:pt idx="150">
                  <c:v>0.34527251190476216</c:v>
                </c:pt>
                <c:pt idx="151">
                  <c:v>0.52267232142857178</c:v>
                </c:pt>
                <c:pt idx="152">
                  <c:v>0.48096242857142535</c:v>
                </c:pt>
                <c:pt idx="153">
                  <c:v>0.18065592857142754</c:v>
                </c:pt>
                <c:pt idx="154">
                  <c:v>0.43048072619047617</c:v>
                </c:pt>
                <c:pt idx="155">
                  <c:v>0.26819753571428429</c:v>
                </c:pt>
                <c:pt idx="156">
                  <c:v>0.50463933333333344</c:v>
                </c:pt>
                <c:pt idx="157">
                  <c:v>-0.13246608928571924</c:v>
                </c:pt>
                <c:pt idx="158">
                  <c:v>0.16475899999999921</c:v>
                </c:pt>
                <c:pt idx="159">
                  <c:v>0.56178515476190505</c:v>
                </c:pt>
                <c:pt idx="160">
                  <c:v>-0.34706888095237964</c:v>
                </c:pt>
                <c:pt idx="161">
                  <c:v>0.41624722023809557</c:v>
                </c:pt>
                <c:pt idx="162">
                  <c:v>0.28796911904761907</c:v>
                </c:pt>
                <c:pt idx="163">
                  <c:v>0.29798942857142841</c:v>
                </c:pt>
                <c:pt idx="164">
                  <c:v>0.28377963095238101</c:v>
                </c:pt>
                <c:pt idx="165">
                  <c:v>0.33045463095238081</c:v>
                </c:pt>
                <c:pt idx="166">
                  <c:v>0.22720355952380977</c:v>
                </c:pt>
                <c:pt idx="167">
                  <c:v>0.20291495238095614</c:v>
                </c:pt>
                <c:pt idx="168">
                  <c:v>0.32209974404762054</c:v>
                </c:pt>
                <c:pt idx="169">
                  <c:v>0.94695141071428424</c:v>
                </c:pt>
                <c:pt idx="170">
                  <c:v>0.17365005952381196</c:v>
                </c:pt>
                <c:pt idx="171">
                  <c:v>-0.80381085119047668</c:v>
                </c:pt>
                <c:pt idx="172">
                  <c:v>0.40251444642857326</c:v>
                </c:pt>
                <c:pt idx="173">
                  <c:v>-0.30022983333333642</c:v>
                </c:pt>
                <c:pt idx="174">
                  <c:v>-8.6555404761904597E-2</c:v>
                </c:pt>
                <c:pt idx="175">
                  <c:v>0.30818982142857543</c:v>
                </c:pt>
                <c:pt idx="176">
                  <c:v>-0.16697305952380948</c:v>
                </c:pt>
                <c:pt idx="177">
                  <c:v>-8.7409952380952838E-2</c:v>
                </c:pt>
                <c:pt idx="178">
                  <c:v>0.40480422619047651</c:v>
                </c:pt>
                <c:pt idx="179">
                  <c:v>0.48196951190476289</c:v>
                </c:pt>
                <c:pt idx="180">
                  <c:v>0.24964972619047643</c:v>
                </c:pt>
                <c:pt idx="181">
                  <c:v>-0.60003087499999985</c:v>
                </c:pt>
                <c:pt idx="182">
                  <c:v>0.41825505357142756</c:v>
                </c:pt>
                <c:pt idx="183">
                  <c:v>-0.15027182142857232</c:v>
                </c:pt>
                <c:pt idx="184">
                  <c:v>0.21589222619047616</c:v>
                </c:pt>
                <c:pt idx="185">
                  <c:v>0.26476116666666671</c:v>
                </c:pt>
                <c:pt idx="186">
                  <c:v>0.22236004761904771</c:v>
                </c:pt>
                <c:pt idx="187">
                  <c:v>0.50349847619047416</c:v>
                </c:pt>
                <c:pt idx="188">
                  <c:v>0.20969564285714437</c:v>
                </c:pt>
                <c:pt idx="189">
                  <c:v>0.12974609523809644</c:v>
                </c:pt>
                <c:pt idx="190">
                  <c:v>0.1633703869047618</c:v>
                </c:pt>
                <c:pt idx="191">
                  <c:v>9.7083630952381039E-2</c:v>
                </c:pt>
                <c:pt idx="192">
                  <c:v>0.17001020833333325</c:v>
                </c:pt>
                <c:pt idx="193">
                  <c:v>-0.2607092142857157</c:v>
                </c:pt>
                <c:pt idx="194">
                  <c:v>0.23820528571428556</c:v>
                </c:pt>
                <c:pt idx="195">
                  <c:v>0.1491473214285719</c:v>
                </c:pt>
                <c:pt idx="196">
                  <c:v>5.2954410714286304E-2</c:v>
                </c:pt>
                <c:pt idx="197">
                  <c:v>0.15763281547619018</c:v>
                </c:pt>
                <c:pt idx="198">
                  <c:v>-3.0763708333330975E-2</c:v>
                </c:pt>
                <c:pt idx="199">
                  <c:v>0.20319341666666446</c:v>
                </c:pt>
                <c:pt idx="200">
                  <c:v>-0.15072209523809477</c:v>
                </c:pt>
                <c:pt idx="201">
                  <c:v>0.14640670833333358</c:v>
                </c:pt>
                <c:pt idx="202">
                  <c:v>0.17945719642857227</c:v>
                </c:pt>
                <c:pt idx="203">
                  <c:v>0.10907021428571495</c:v>
                </c:pt>
                <c:pt idx="204">
                  <c:v>6.2491952380954174E-2</c:v>
                </c:pt>
                <c:pt idx="205">
                  <c:v>0.35393125595238129</c:v>
                </c:pt>
                <c:pt idx="206">
                  <c:v>0.35366923809523687</c:v>
                </c:pt>
                <c:pt idx="207">
                  <c:v>-0.12480060119047565</c:v>
                </c:pt>
                <c:pt idx="208">
                  <c:v>0.21863848809523745</c:v>
                </c:pt>
                <c:pt idx="209">
                  <c:v>0.10154698214285673</c:v>
                </c:pt>
                <c:pt idx="210">
                  <c:v>0.1047734166666725</c:v>
                </c:pt>
                <c:pt idx="211">
                  <c:v>8.4829321428570026E-2</c:v>
                </c:pt>
                <c:pt idx="212">
                  <c:v>0.10485492261904916</c:v>
                </c:pt>
                <c:pt idx="213">
                  <c:v>0.11378897023808676</c:v>
                </c:pt>
                <c:pt idx="214">
                  <c:v>0.14554330952380962</c:v>
                </c:pt>
                <c:pt idx="215">
                  <c:v>1.2829345238099421E-2</c:v>
                </c:pt>
                <c:pt idx="216">
                  <c:v>1.3721845238094943E-2</c:v>
                </c:pt>
                <c:pt idx="217">
                  <c:v>0.14230051785714282</c:v>
                </c:pt>
                <c:pt idx="218">
                  <c:v>0.12836781547619047</c:v>
                </c:pt>
                <c:pt idx="219">
                  <c:v>0.26120227380952343</c:v>
                </c:pt>
                <c:pt idx="220">
                  <c:v>4.3216333333333523E-2</c:v>
                </c:pt>
                <c:pt idx="221">
                  <c:v>-7.708842261904536E-2</c:v>
                </c:pt>
                <c:pt idx="222">
                  <c:v>4.8614017857138592E-2</c:v>
                </c:pt>
                <c:pt idx="223">
                  <c:v>-5.6390827380952468E-2</c:v>
                </c:pt>
                <c:pt idx="224">
                  <c:v>0.16179358333333127</c:v>
                </c:pt>
                <c:pt idx="225">
                  <c:v>3.6173202380953562E-2</c:v>
                </c:pt>
                <c:pt idx="226">
                  <c:v>0.18170251785714253</c:v>
                </c:pt>
                <c:pt idx="227">
                  <c:v>-0.12839165476190506</c:v>
                </c:pt>
                <c:pt idx="228">
                  <c:v>-4.2216999999999727E-2</c:v>
                </c:pt>
                <c:pt idx="229">
                  <c:v>2.1712357142858796E-2</c:v>
                </c:pt>
                <c:pt idx="230">
                  <c:v>2.517238095238028E-2</c:v>
                </c:pt>
                <c:pt idx="231">
                  <c:v>-5.0808476190475016E-2</c:v>
                </c:pt>
                <c:pt idx="232">
                  <c:v>-4.5393678571428175E-2</c:v>
                </c:pt>
                <c:pt idx="233">
                  <c:v>9.628130952381575E-3</c:v>
                </c:pt>
                <c:pt idx="234">
                  <c:v>-8.7952083333333597E-3</c:v>
                </c:pt>
                <c:pt idx="235">
                  <c:v>-1.0144071428568324E-2</c:v>
                </c:pt>
                <c:pt idx="236">
                  <c:v>1.3948345238094184E-2</c:v>
                </c:pt>
                <c:pt idx="237">
                  <c:v>-9.96726190507502E-5</c:v>
                </c:pt>
              </c:numCache>
            </c:numRef>
          </c:xVal>
          <c:yVal>
            <c:numRef>
              <c:f>'HFvsCTRL-K1volcano'!$H$40:$H$277</c:f>
              <c:numCache>
                <c:formatCode>General</c:formatCode>
                <c:ptCount val="238"/>
                <c:pt idx="0">
                  <c:v>14.472514541645308</c:v>
                </c:pt>
                <c:pt idx="1">
                  <c:v>13.838545624303874</c:v>
                </c:pt>
                <c:pt idx="2">
                  <c:v>12.736896916256935</c:v>
                </c:pt>
                <c:pt idx="3">
                  <c:v>11.12201433248957</c:v>
                </c:pt>
                <c:pt idx="4">
                  <c:v>10.878452814020362</c:v>
                </c:pt>
                <c:pt idx="5">
                  <c:v>10.486972876613024</c:v>
                </c:pt>
                <c:pt idx="6">
                  <c:v>10.123985812951425</c:v>
                </c:pt>
                <c:pt idx="7">
                  <c:v>9.6179010467625599</c:v>
                </c:pt>
                <c:pt idx="8">
                  <c:v>9.4163668367188205</c:v>
                </c:pt>
                <c:pt idx="9">
                  <c:v>9.1703404494381999</c:v>
                </c:pt>
                <c:pt idx="10">
                  <c:v>8.804750700262888</c:v>
                </c:pt>
                <c:pt idx="11">
                  <c:v>8.6307774116231766</c:v>
                </c:pt>
                <c:pt idx="12">
                  <c:v>8.0463126924131387</c:v>
                </c:pt>
                <c:pt idx="13">
                  <c:v>8.0463126924131387</c:v>
                </c:pt>
                <c:pt idx="14">
                  <c:v>8.0207622926823596</c:v>
                </c:pt>
                <c:pt idx="15">
                  <c:v>7.6710374143308799</c:v>
                </c:pt>
                <c:pt idx="16">
                  <c:v>7.6710374143308799</c:v>
                </c:pt>
                <c:pt idx="17">
                  <c:v>7.6458518667879538</c:v>
                </c:pt>
                <c:pt idx="18">
                  <c:v>7.6397076544527813</c:v>
                </c:pt>
                <c:pt idx="19">
                  <c:v>7.5965014900951795</c:v>
                </c:pt>
                <c:pt idx="20">
                  <c:v>7.565990731841211</c:v>
                </c:pt>
                <c:pt idx="21">
                  <c:v>7.4452167827696654</c:v>
                </c:pt>
                <c:pt idx="22">
                  <c:v>7.3258206556855301</c:v>
                </c:pt>
                <c:pt idx="23">
                  <c:v>7.2868845878044946</c:v>
                </c:pt>
                <c:pt idx="24">
                  <c:v>7.2859509458896561</c:v>
                </c:pt>
                <c:pt idx="25">
                  <c:v>7.2476303087963379</c:v>
                </c:pt>
                <c:pt idx="26">
                  <c:v>7.2026917347311086</c:v>
                </c:pt>
                <c:pt idx="27">
                  <c:v>7.152679955512891</c:v>
                </c:pt>
                <c:pt idx="28">
                  <c:v>7.1028429569148592</c:v>
                </c:pt>
                <c:pt idx="29">
                  <c:v>7.0834707094478881</c:v>
                </c:pt>
                <c:pt idx="30">
                  <c:v>7.0367734303682914</c:v>
                </c:pt>
                <c:pt idx="31">
                  <c:v>7.0295380587990177</c:v>
                </c:pt>
                <c:pt idx="32">
                  <c:v>6.9832941345137556</c:v>
                </c:pt>
                <c:pt idx="33">
                  <c:v>6.9832941345137556</c:v>
                </c:pt>
                <c:pt idx="34">
                  <c:v>6.635840888137821</c:v>
                </c:pt>
                <c:pt idx="35">
                  <c:v>6.2255144775894875</c:v>
                </c:pt>
                <c:pt idx="36">
                  <c:v>6.2206186558114211</c:v>
                </c:pt>
                <c:pt idx="37">
                  <c:v>6.0588451422791536</c:v>
                </c:pt>
                <c:pt idx="38">
                  <c:v>5.9020162301511423</c:v>
                </c:pt>
                <c:pt idx="39">
                  <c:v>5.8654888928966473</c:v>
                </c:pt>
                <c:pt idx="40">
                  <c:v>5.8086756050789967</c:v>
                </c:pt>
                <c:pt idx="41">
                  <c:v>5.6202833658292182</c:v>
                </c:pt>
                <c:pt idx="42">
                  <c:v>5.6065429709644121</c:v>
                </c:pt>
                <c:pt idx="43">
                  <c:v>5.5697943350561623</c:v>
                </c:pt>
                <c:pt idx="44">
                  <c:v>5.4802114814041962</c:v>
                </c:pt>
                <c:pt idx="45">
                  <c:v>5.3620849747314629</c:v>
                </c:pt>
                <c:pt idx="46">
                  <c:v>5.3372212383160011</c:v>
                </c:pt>
                <c:pt idx="47">
                  <c:v>5.3372212383160011</c:v>
                </c:pt>
                <c:pt idx="48">
                  <c:v>5.3372212383160011</c:v>
                </c:pt>
                <c:pt idx="49">
                  <c:v>5.3216282051223578</c:v>
                </c:pt>
                <c:pt idx="50">
                  <c:v>5.2824173185495509</c:v>
                </c:pt>
                <c:pt idx="51">
                  <c:v>5.2824173185495509</c:v>
                </c:pt>
                <c:pt idx="52">
                  <c:v>5.258445955320119</c:v>
                </c:pt>
                <c:pt idx="53">
                  <c:v>5.1596694431378305</c:v>
                </c:pt>
                <c:pt idx="54">
                  <c:v>5.1084471881057256</c:v>
                </c:pt>
                <c:pt idx="55">
                  <c:v>5.0791283633009581</c:v>
                </c:pt>
                <c:pt idx="56">
                  <c:v>4.9131116098812395</c:v>
                </c:pt>
                <c:pt idx="57">
                  <c:v>4.8364954615537936</c:v>
                </c:pt>
                <c:pt idx="58">
                  <c:v>4.7965657267470343</c:v>
                </c:pt>
                <c:pt idx="59">
                  <c:v>4.6477753362690377</c:v>
                </c:pt>
                <c:pt idx="60">
                  <c:v>4.4737836264328887</c:v>
                </c:pt>
                <c:pt idx="61">
                  <c:v>4.4545813985202098</c:v>
                </c:pt>
                <c:pt idx="62">
                  <c:v>4.4545813985202098</c:v>
                </c:pt>
                <c:pt idx="63">
                  <c:v>4.4545813985202098</c:v>
                </c:pt>
                <c:pt idx="64">
                  <c:v>4.4414747931543852</c:v>
                </c:pt>
                <c:pt idx="65">
                  <c:v>4.255571043414176</c:v>
                </c:pt>
                <c:pt idx="66">
                  <c:v>4.2445527016736895</c:v>
                </c:pt>
                <c:pt idx="67">
                  <c:v>4.2435948950851978</c:v>
                </c:pt>
                <c:pt idx="68">
                  <c:v>4.2373598424901591</c:v>
                </c:pt>
                <c:pt idx="69">
                  <c:v>4.2057481025019365</c:v>
                </c:pt>
                <c:pt idx="70">
                  <c:v>4.0752966400634794</c:v>
                </c:pt>
                <c:pt idx="71">
                  <c:v>3.9174915261183263</c:v>
                </c:pt>
                <c:pt idx="72">
                  <c:v>3.8762191472654859</c:v>
                </c:pt>
                <c:pt idx="73">
                  <c:v>3.7829226848495425</c:v>
                </c:pt>
                <c:pt idx="74">
                  <c:v>3.7829226848495425</c:v>
                </c:pt>
                <c:pt idx="75">
                  <c:v>3.7462998859634702</c:v>
                </c:pt>
                <c:pt idx="76">
                  <c:v>3.6672881667057986</c:v>
                </c:pt>
                <c:pt idx="77">
                  <c:v>3.6165319426847815</c:v>
                </c:pt>
                <c:pt idx="78">
                  <c:v>3.5089074993220781</c:v>
                </c:pt>
                <c:pt idx="79">
                  <c:v>3.4155739815416233</c:v>
                </c:pt>
                <c:pt idx="80">
                  <c:v>3.3884260606333569</c:v>
                </c:pt>
                <c:pt idx="81">
                  <c:v>3.3752997915078704</c:v>
                </c:pt>
                <c:pt idx="82">
                  <c:v>3.3517575152300578</c:v>
                </c:pt>
                <c:pt idx="83">
                  <c:v>3.3517575152300578</c:v>
                </c:pt>
                <c:pt idx="84">
                  <c:v>3.3517575152300578</c:v>
                </c:pt>
                <c:pt idx="85">
                  <c:v>3.3485227378394873</c:v>
                </c:pt>
                <c:pt idx="86">
                  <c:v>3.2733563212662178</c:v>
                </c:pt>
                <c:pt idx="87">
                  <c:v>3.1941403838949642</c:v>
                </c:pt>
                <c:pt idx="88">
                  <c:v>3.1177506181910428</c:v>
                </c:pt>
                <c:pt idx="89">
                  <c:v>3.0003262921807448</c:v>
                </c:pt>
                <c:pt idx="90">
                  <c:v>2.9993444557530662</c:v>
                </c:pt>
                <c:pt idx="91">
                  <c:v>2.9832021137309748</c:v>
                </c:pt>
                <c:pt idx="92">
                  <c:v>2.9272651359685513</c:v>
                </c:pt>
                <c:pt idx="93">
                  <c:v>2.9122651949825742</c:v>
                </c:pt>
                <c:pt idx="94">
                  <c:v>2.9035315623041251</c:v>
                </c:pt>
                <c:pt idx="95">
                  <c:v>2.8974692802025674</c:v>
                </c:pt>
                <c:pt idx="96">
                  <c:v>2.8814107456886391</c:v>
                </c:pt>
                <c:pt idx="97">
                  <c:v>2.8814107456886391</c:v>
                </c:pt>
                <c:pt idx="98">
                  <c:v>2.8652054337060582</c:v>
                </c:pt>
                <c:pt idx="99">
                  <c:v>2.7743126233762592</c:v>
                </c:pt>
                <c:pt idx="100">
                  <c:v>2.7309224848591072</c:v>
                </c:pt>
                <c:pt idx="101">
                  <c:v>2.6511325091049032</c:v>
                </c:pt>
                <c:pt idx="102">
                  <c:v>2.6511325091049032</c:v>
                </c:pt>
                <c:pt idx="103">
                  <c:v>2.642246774601781</c:v>
                </c:pt>
                <c:pt idx="104">
                  <c:v>2.642246774601781</c:v>
                </c:pt>
                <c:pt idx="105">
                  <c:v>2.642246774601781</c:v>
                </c:pt>
                <c:pt idx="106">
                  <c:v>2.6202194079545307</c:v>
                </c:pt>
                <c:pt idx="107">
                  <c:v>2.6202194079545307</c:v>
                </c:pt>
                <c:pt idx="108">
                  <c:v>2.6158205602755094</c:v>
                </c:pt>
                <c:pt idx="109">
                  <c:v>2.6156116329176631</c:v>
                </c:pt>
                <c:pt idx="110">
                  <c:v>2.5645596854422688</c:v>
                </c:pt>
                <c:pt idx="111">
                  <c:v>2.5454051229586683</c:v>
                </c:pt>
                <c:pt idx="112">
                  <c:v>2.502615020373868</c:v>
                </c:pt>
                <c:pt idx="113">
                  <c:v>2.4879563172482793</c:v>
                </c:pt>
                <c:pt idx="114">
                  <c:v>2.4862070016549858</c:v>
                </c:pt>
                <c:pt idx="115">
                  <c:v>2.4338506441582859</c:v>
                </c:pt>
                <c:pt idx="116">
                  <c:v>2.4118778805000241</c:v>
                </c:pt>
                <c:pt idx="117">
                  <c:v>2.4118778805000241</c:v>
                </c:pt>
                <c:pt idx="118">
                  <c:v>2.3621760239599814</c:v>
                </c:pt>
                <c:pt idx="119">
                  <c:v>2.236927443062493</c:v>
                </c:pt>
                <c:pt idx="120">
                  <c:v>2.2236233393962346</c:v>
                </c:pt>
                <c:pt idx="121">
                  <c:v>2.1474020268674696</c:v>
                </c:pt>
                <c:pt idx="122">
                  <c:v>2.1335446547817378</c:v>
                </c:pt>
                <c:pt idx="123">
                  <c:v>2.0458225898461642</c:v>
                </c:pt>
                <c:pt idx="124">
                  <c:v>2.0393621293547959</c:v>
                </c:pt>
                <c:pt idx="125">
                  <c:v>2.0119982230563549</c:v>
                </c:pt>
                <c:pt idx="126">
                  <c:v>2.0119982230563549</c:v>
                </c:pt>
                <c:pt idx="127">
                  <c:v>2.0076506139871899</c:v>
                </c:pt>
                <c:pt idx="128">
                  <c:v>1.957338506475244</c:v>
                </c:pt>
                <c:pt idx="129">
                  <c:v>1.9528844978646211</c:v>
                </c:pt>
                <c:pt idx="130">
                  <c:v>1.9492876328929105</c:v>
                </c:pt>
                <c:pt idx="131">
                  <c:v>1.8965996196198784</c:v>
                </c:pt>
                <c:pt idx="132">
                  <c:v>1.8823330984642657</c:v>
                </c:pt>
                <c:pt idx="133">
                  <c:v>1.8541090349378717</c:v>
                </c:pt>
                <c:pt idx="134">
                  <c:v>1.8380454060164595</c:v>
                </c:pt>
                <c:pt idx="135">
                  <c:v>1.7750914795407782</c:v>
                </c:pt>
                <c:pt idx="136">
                  <c:v>1.7705947624959988</c:v>
                </c:pt>
                <c:pt idx="137">
                  <c:v>1.762739650514008</c:v>
                </c:pt>
                <c:pt idx="138">
                  <c:v>1.761438487849367</c:v>
                </c:pt>
                <c:pt idx="139">
                  <c:v>1.756246207202381</c:v>
                </c:pt>
                <c:pt idx="140">
                  <c:v>1.7037317979956998</c:v>
                </c:pt>
                <c:pt idx="141">
                  <c:v>1.6996096658523698</c:v>
                </c:pt>
                <c:pt idx="142">
                  <c:v>1.6996096658523698</c:v>
                </c:pt>
                <c:pt idx="143">
                  <c:v>1.6604033541235228</c:v>
                </c:pt>
                <c:pt idx="144">
                  <c:v>1.6604033541235228</c:v>
                </c:pt>
                <c:pt idx="145">
                  <c:v>1.6526145183463554</c:v>
                </c:pt>
                <c:pt idx="146">
                  <c:v>1.6359674016433339</c:v>
                </c:pt>
                <c:pt idx="147">
                  <c:v>1.6278568876895969</c:v>
                </c:pt>
                <c:pt idx="148">
                  <c:v>1.6188908468666912</c:v>
                </c:pt>
                <c:pt idx="149">
                  <c:v>1.5065010829682148</c:v>
                </c:pt>
                <c:pt idx="150">
                  <c:v>1.4924677231477215</c:v>
                </c:pt>
                <c:pt idx="151">
                  <c:v>1.467717959104309</c:v>
                </c:pt>
                <c:pt idx="152">
                  <c:v>1.4386875491398097</c:v>
                </c:pt>
                <c:pt idx="153">
                  <c:v>1.4386875491398097</c:v>
                </c:pt>
                <c:pt idx="154">
                  <c:v>1.4131945642492685</c:v>
                </c:pt>
                <c:pt idx="155">
                  <c:v>1.4104659671893414</c:v>
                </c:pt>
                <c:pt idx="156">
                  <c:v>1.3693672704544364</c:v>
                </c:pt>
                <c:pt idx="157">
                  <c:v>1.3586789806128978</c:v>
                </c:pt>
                <c:pt idx="158">
                  <c:v>1.3009166011937541</c:v>
                </c:pt>
                <c:pt idx="159">
                  <c:v>1.2464118024706909</c:v>
                </c:pt>
                <c:pt idx="160">
                  <c:v>1.2231035764398659</c:v>
                </c:pt>
                <c:pt idx="161">
                  <c:v>1.2045977817931472</c:v>
                </c:pt>
                <c:pt idx="162">
                  <c:v>1.1800022003446498</c:v>
                </c:pt>
                <c:pt idx="163">
                  <c:v>1.154153598448139</c:v>
                </c:pt>
                <c:pt idx="164">
                  <c:v>1.1477780635371742</c:v>
                </c:pt>
                <c:pt idx="165">
                  <c:v>1.1380103520370222</c:v>
                </c:pt>
                <c:pt idx="166">
                  <c:v>1.1124233591796322</c:v>
                </c:pt>
                <c:pt idx="167">
                  <c:v>1.0939680835688232</c:v>
                </c:pt>
                <c:pt idx="168">
                  <c:v>1.0939680835688232</c:v>
                </c:pt>
                <c:pt idx="169">
                  <c:v>1.0932287637319185</c:v>
                </c:pt>
                <c:pt idx="170">
                  <c:v>1.0697824499607391</c:v>
                </c:pt>
                <c:pt idx="171">
                  <c:v>1.0697824499607391</c:v>
                </c:pt>
                <c:pt idx="172">
                  <c:v>0.99135087824565737</c:v>
                </c:pt>
                <c:pt idx="173">
                  <c:v>0.99100472779405246</c:v>
                </c:pt>
                <c:pt idx="174">
                  <c:v>0.94474965193873073</c:v>
                </c:pt>
                <c:pt idx="175">
                  <c:v>0.85780654207522411</c:v>
                </c:pt>
                <c:pt idx="176">
                  <c:v>0.75410095200394067</c:v>
                </c:pt>
                <c:pt idx="177">
                  <c:v>0.7518031052054196</c:v>
                </c:pt>
                <c:pt idx="178">
                  <c:v>0.7442654859242539</c:v>
                </c:pt>
                <c:pt idx="179">
                  <c:v>0.73891358339798985</c:v>
                </c:pt>
                <c:pt idx="180">
                  <c:v>0.72756936269231254</c:v>
                </c:pt>
                <c:pt idx="181">
                  <c:v>0.71345721472606172</c:v>
                </c:pt>
                <c:pt idx="182">
                  <c:v>0.68805427892630477</c:v>
                </c:pt>
                <c:pt idx="183">
                  <c:v>0.68663573296613967</c:v>
                </c:pt>
                <c:pt idx="184">
                  <c:v>0.65103685678464973</c:v>
                </c:pt>
                <c:pt idx="185">
                  <c:v>0.64557067522104561</c:v>
                </c:pt>
                <c:pt idx="186">
                  <c:v>0.61387272584042418</c:v>
                </c:pt>
                <c:pt idx="187">
                  <c:v>0.60229834098479063</c:v>
                </c:pt>
                <c:pt idx="188">
                  <c:v>0.60229834098479063</c:v>
                </c:pt>
                <c:pt idx="189">
                  <c:v>0.57370472715485465</c:v>
                </c:pt>
                <c:pt idx="190">
                  <c:v>0.57370472715485465</c:v>
                </c:pt>
                <c:pt idx="191">
                  <c:v>0.55193981536257353</c:v>
                </c:pt>
                <c:pt idx="192">
                  <c:v>0.52218089004370882</c:v>
                </c:pt>
                <c:pt idx="193">
                  <c:v>0.49395902123292307</c:v>
                </c:pt>
                <c:pt idx="194">
                  <c:v>0.49314053855759771</c:v>
                </c:pt>
                <c:pt idx="195">
                  <c:v>0.4898661856355343</c:v>
                </c:pt>
                <c:pt idx="196">
                  <c:v>0.45797636310939233</c:v>
                </c:pt>
                <c:pt idx="197">
                  <c:v>0.45212238218317358</c:v>
                </c:pt>
                <c:pt idx="198">
                  <c:v>0.45170729695275558</c:v>
                </c:pt>
                <c:pt idx="199">
                  <c:v>0.43129636560733864</c:v>
                </c:pt>
                <c:pt idx="200">
                  <c:v>0.41468046352294735</c:v>
                </c:pt>
                <c:pt idx="201">
                  <c:v>0.41229839454966022</c:v>
                </c:pt>
                <c:pt idx="202">
                  <c:v>0.39750913455832992</c:v>
                </c:pt>
                <c:pt idx="203">
                  <c:v>0.38970270576384175</c:v>
                </c:pt>
                <c:pt idx="204">
                  <c:v>0.35498422335200008</c:v>
                </c:pt>
                <c:pt idx="205">
                  <c:v>0.35051380129932813</c:v>
                </c:pt>
                <c:pt idx="206">
                  <c:v>0.33622922655960841</c:v>
                </c:pt>
                <c:pt idx="207">
                  <c:v>0.33111334878925203</c:v>
                </c:pt>
                <c:pt idx="208">
                  <c:v>0.32514938607711713</c:v>
                </c:pt>
                <c:pt idx="209">
                  <c:v>0.30888851996523942</c:v>
                </c:pt>
                <c:pt idx="210">
                  <c:v>0.30631820653081998</c:v>
                </c:pt>
                <c:pt idx="211">
                  <c:v>0.30343928038539625</c:v>
                </c:pt>
                <c:pt idx="212">
                  <c:v>0.30343928038539625</c:v>
                </c:pt>
                <c:pt idx="213">
                  <c:v>0.29977458751942715</c:v>
                </c:pt>
                <c:pt idx="214">
                  <c:v>0.27661738746406783</c:v>
                </c:pt>
                <c:pt idx="215">
                  <c:v>0.24819215503900025</c:v>
                </c:pt>
                <c:pt idx="216">
                  <c:v>0.24189696699488172</c:v>
                </c:pt>
                <c:pt idx="217">
                  <c:v>0.23745408175334681</c:v>
                </c:pt>
                <c:pt idx="218">
                  <c:v>0.21733617144578835</c:v>
                </c:pt>
                <c:pt idx="219">
                  <c:v>0.20422854720489927</c:v>
                </c:pt>
                <c:pt idx="220">
                  <c:v>0.19438840978345914</c:v>
                </c:pt>
                <c:pt idx="221">
                  <c:v>0.19438840978345914</c:v>
                </c:pt>
                <c:pt idx="222">
                  <c:v>0.17631189588292809</c:v>
                </c:pt>
                <c:pt idx="223">
                  <c:v>0.17584217791990042</c:v>
                </c:pt>
                <c:pt idx="224">
                  <c:v>0.15162531404139973</c:v>
                </c:pt>
                <c:pt idx="225">
                  <c:v>0.14440902488312715</c:v>
                </c:pt>
                <c:pt idx="226">
                  <c:v>0.13767274082768757</c:v>
                </c:pt>
                <c:pt idx="227">
                  <c:v>0.1173663262500176</c:v>
                </c:pt>
                <c:pt idx="228">
                  <c:v>0.10558598660873561</c:v>
                </c:pt>
                <c:pt idx="229">
                  <c:v>9.9091687431956607E-2</c:v>
                </c:pt>
                <c:pt idx="230">
                  <c:v>5.7504176853622788E-2</c:v>
                </c:pt>
                <c:pt idx="231">
                  <c:v>4.3982405088881932E-2</c:v>
                </c:pt>
                <c:pt idx="232">
                  <c:v>4.0871219733494737E-2</c:v>
                </c:pt>
                <c:pt idx="233">
                  <c:v>2.6126581529594954E-2</c:v>
                </c:pt>
                <c:pt idx="234">
                  <c:v>2.2042119856719451E-2</c:v>
                </c:pt>
                <c:pt idx="235">
                  <c:v>2.1694990258024908E-2</c:v>
                </c:pt>
                <c:pt idx="236">
                  <c:v>1.952689859296166E-2</c:v>
                </c:pt>
                <c:pt idx="237">
                  <c:v>7.9406651879453669E-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697-4DA2-B756-9F712B98FA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87689248"/>
        <c:axId val="487683344"/>
      </c:scatterChart>
      <c:scatterChart>
        <c:scatterStyle val="smoothMarker"/>
        <c:varyColors val="0"/>
        <c:ser>
          <c:idx val="3"/>
          <c:order val="3"/>
          <c:tx>
            <c:v>down</c:v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HFvsCTRL-K1volcano'!$L$2:$L$3</c:f>
              <c:numCache>
                <c:formatCode>General</c:formatCode>
                <c:ptCount val="2"/>
                <c:pt idx="0">
                  <c:v>-1</c:v>
                </c:pt>
                <c:pt idx="1">
                  <c:v>-1</c:v>
                </c:pt>
              </c:numCache>
            </c:numRef>
          </c:xVal>
          <c:yVal>
            <c:numRef>
              <c:f>'HFvsCTRL-K1volcano'!$M$2:$M$3</c:f>
              <c:numCache>
                <c:formatCode>General</c:formatCode>
                <c:ptCount val="2"/>
                <c:pt idx="0">
                  <c:v>0</c:v>
                </c:pt>
                <c:pt idx="1">
                  <c:v>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697-4DA2-B756-9F712B98FADE}"/>
            </c:ext>
          </c:extLst>
        </c:ser>
        <c:ser>
          <c:idx val="4"/>
          <c:order val="4"/>
          <c:tx>
            <c:v>up</c:v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HFvsCTRL-K1volcano'!$O$2:$O$3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xVal>
          <c:yVal>
            <c:numRef>
              <c:f>'HFvsCTRL-K1volcano'!$P$2:$P$3</c:f>
              <c:numCache>
                <c:formatCode>General</c:formatCode>
                <c:ptCount val="2"/>
                <c:pt idx="0">
                  <c:v>0</c:v>
                </c:pt>
                <c:pt idx="1">
                  <c:v>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697-4DA2-B756-9F712B98FADE}"/>
            </c:ext>
          </c:extLst>
        </c:ser>
        <c:ser>
          <c:idx val="5"/>
          <c:order val="5"/>
          <c:tx>
            <c:v>p-val</c:v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HFvsCTRL-K1volcano'!$R$2:$R$3</c:f>
              <c:numCache>
                <c:formatCode>General</c:formatCode>
                <c:ptCount val="2"/>
                <c:pt idx="0">
                  <c:v>-3</c:v>
                </c:pt>
                <c:pt idx="1">
                  <c:v>6</c:v>
                </c:pt>
              </c:numCache>
            </c:numRef>
          </c:xVal>
          <c:yVal>
            <c:numRef>
              <c:f>'HFvsCTRL-K1volcano'!$S$2:$S$3</c:f>
              <c:numCache>
                <c:formatCode>General</c:formatCode>
                <c:ptCount val="2"/>
                <c:pt idx="0">
                  <c:v>1.3010299956639813</c:v>
                </c:pt>
                <c:pt idx="1">
                  <c:v>1.30102999566398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697-4DA2-B756-9F712B98FA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56178656"/>
        <c:axId val="656173736"/>
      </c:scatterChart>
      <c:valAx>
        <c:axId val="487689248"/>
        <c:scaling>
          <c:orientation val="minMax"/>
          <c:max val="6"/>
          <c:min val="-3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log2 fold change (HF vs CTRL)</a:t>
                </a:r>
              </a:p>
            </c:rich>
          </c:tx>
          <c:layout>
            <c:manualLayout>
              <c:xMode val="edge"/>
              <c:yMode val="edge"/>
              <c:x val="0.30782856334089614"/>
              <c:y val="0.939324391519998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87683344"/>
        <c:crosses val="autoZero"/>
        <c:crossBetween val="midCat"/>
      </c:valAx>
      <c:valAx>
        <c:axId val="487683344"/>
        <c:scaling>
          <c:orientation val="minMax"/>
          <c:max val="2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10 FDR adj. P val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87689248"/>
        <c:crossesAt val="-3"/>
        <c:crossBetween val="midCat"/>
      </c:valAx>
      <c:valAx>
        <c:axId val="65617373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656178656"/>
        <c:crosses val="max"/>
        <c:crossBetween val="midCat"/>
      </c:valAx>
      <c:valAx>
        <c:axId val="65617865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561737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cs-C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significan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'Q4vsQ1-K1volcano'!$C$2:$C$5</c:f>
              <c:numCache>
                <c:formatCode>General</c:formatCode>
                <c:ptCount val="4"/>
                <c:pt idx="0">
                  <c:v>0.44728500000000082</c:v>
                </c:pt>
                <c:pt idx="1">
                  <c:v>0.48129750000000016</c:v>
                </c:pt>
                <c:pt idx="2">
                  <c:v>0.71851474999999976</c:v>
                </c:pt>
                <c:pt idx="3">
                  <c:v>0.36300899999999636</c:v>
                </c:pt>
              </c:numCache>
            </c:numRef>
          </c:xVal>
          <c:yVal>
            <c:numRef>
              <c:f>'Q4vsQ1-K1volcano'!$H$2:$H$5</c:f>
              <c:numCache>
                <c:formatCode>General</c:formatCode>
                <c:ptCount val="4"/>
                <c:pt idx="0">
                  <c:v>1.5265987478938869</c:v>
                </c:pt>
                <c:pt idx="1">
                  <c:v>1.5265987478938869</c:v>
                </c:pt>
                <c:pt idx="2">
                  <c:v>1.5265987478938869</c:v>
                </c:pt>
                <c:pt idx="3">
                  <c:v>1.44615190164175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933-493E-8BF3-503CA958E314}"/>
            </c:ext>
          </c:extLst>
        </c:ser>
        <c:ser>
          <c:idx val="1"/>
          <c:order val="1"/>
          <c:tx>
            <c:v>non-significan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Q4vsQ1-K1volcano'!$C$6:$C$277</c:f>
              <c:numCache>
                <c:formatCode>General</c:formatCode>
                <c:ptCount val="272"/>
                <c:pt idx="0">
                  <c:v>0.38888174999999947</c:v>
                </c:pt>
                <c:pt idx="1">
                  <c:v>0.29156099999999885</c:v>
                </c:pt>
                <c:pt idx="2">
                  <c:v>0.14803200000000061</c:v>
                </c:pt>
                <c:pt idx="3">
                  <c:v>1.0054250000000486E-2</c:v>
                </c:pt>
                <c:pt idx="4">
                  <c:v>0.18776399999999782</c:v>
                </c:pt>
                <c:pt idx="5">
                  <c:v>0.26939375000000165</c:v>
                </c:pt>
                <c:pt idx="6">
                  <c:v>0.11680525000000053</c:v>
                </c:pt>
                <c:pt idx="7">
                  <c:v>2.2531750000001516E-2</c:v>
                </c:pt>
                <c:pt idx="8">
                  <c:v>9.9781999999999371E-2</c:v>
                </c:pt>
                <c:pt idx="9">
                  <c:v>0.20599500000000415</c:v>
                </c:pt>
                <c:pt idx="10">
                  <c:v>-0.16077050000000015</c:v>
                </c:pt>
                <c:pt idx="11">
                  <c:v>-9.4414999999998805E-3</c:v>
                </c:pt>
                <c:pt idx="12">
                  <c:v>0.14101575000000111</c:v>
                </c:pt>
                <c:pt idx="13">
                  <c:v>0.36934449999999952</c:v>
                </c:pt>
                <c:pt idx="14">
                  <c:v>1.0807999999999707E-2</c:v>
                </c:pt>
                <c:pt idx="15">
                  <c:v>0.21421374999999898</c:v>
                </c:pt>
                <c:pt idx="16">
                  <c:v>0.2582707500000021</c:v>
                </c:pt>
                <c:pt idx="17">
                  <c:v>0.7279852499999997</c:v>
                </c:pt>
                <c:pt idx="18">
                  <c:v>0.14246674999999787</c:v>
                </c:pt>
                <c:pt idx="19">
                  <c:v>0.16702900000000076</c:v>
                </c:pt>
                <c:pt idx="20">
                  <c:v>9.7331999999998864E-2</c:v>
                </c:pt>
                <c:pt idx="21">
                  <c:v>0.31822824999999977</c:v>
                </c:pt>
                <c:pt idx="22">
                  <c:v>8.4996500000001696E-2</c:v>
                </c:pt>
                <c:pt idx="23">
                  <c:v>0.16708775000000031</c:v>
                </c:pt>
                <c:pt idx="24">
                  <c:v>0.26675200000000387</c:v>
                </c:pt>
                <c:pt idx="25">
                  <c:v>0.15199699999999972</c:v>
                </c:pt>
                <c:pt idx="26">
                  <c:v>-0.19452874999999992</c:v>
                </c:pt>
                <c:pt idx="27">
                  <c:v>0.42654424999999918</c:v>
                </c:pt>
                <c:pt idx="28">
                  <c:v>0.12298824999999702</c:v>
                </c:pt>
                <c:pt idx="29">
                  <c:v>-0.26041599999999931</c:v>
                </c:pt>
                <c:pt idx="30">
                  <c:v>0.24911149999999882</c:v>
                </c:pt>
                <c:pt idx="31">
                  <c:v>0.22593549999999984</c:v>
                </c:pt>
                <c:pt idx="32">
                  <c:v>0.26501475000000241</c:v>
                </c:pt>
                <c:pt idx="33">
                  <c:v>0.26109300000000069</c:v>
                </c:pt>
                <c:pt idx="34">
                  <c:v>3.1161999999999246E-2</c:v>
                </c:pt>
                <c:pt idx="35">
                  <c:v>0.19374874999999925</c:v>
                </c:pt>
                <c:pt idx="36">
                  <c:v>0.31816874999999989</c:v>
                </c:pt>
                <c:pt idx="37">
                  <c:v>-6.5869750000001392E-2</c:v>
                </c:pt>
                <c:pt idx="38">
                  <c:v>0.1641035000000004</c:v>
                </c:pt>
                <c:pt idx="39">
                  <c:v>7.9288500000000539E-2</c:v>
                </c:pt>
                <c:pt idx="40">
                  <c:v>6.5690000000000026E-2</c:v>
                </c:pt>
                <c:pt idx="41">
                  <c:v>0.21399775000000254</c:v>
                </c:pt>
                <c:pt idx="42">
                  <c:v>0.12002500000000182</c:v>
                </c:pt>
                <c:pt idx="43">
                  <c:v>0.25985124999999876</c:v>
                </c:pt>
                <c:pt idx="44">
                  <c:v>0.11148350000000029</c:v>
                </c:pt>
                <c:pt idx="45">
                  <c:v>0.25436425000000007</c:v>
                </c:pt>
                <c:pt idx="46">
                  <c:v>0.18595599999999868</c:v>
                </c:pt>
                <c:pt idx="47">
                  <c:v>6.1407749999999872E-2</c:v>
                </c:pt>
                <c:pt idx="48">
                  <c:v>-2.0496000000001402E-2</c:v>
                </c:pt>
                <c:pt idx="49">
                  <c:v>4.7446749999997095E-2</c:v>
                </c:pt>
                <c:pt idx="50">
                  <c:v>0.12253575000000261</c:v>
                </c:pt>
                <c:pt idx="51">
                  <c:v>0.12564599999999881</c:v>
                </c:pt>
                <c:pt idx="52">
                  <c:v>0.36646674999999895</c:v>
                </c:pt>
                <c:pt idx="53">
                  <c:v>0.16440424999999692</c:v>
                </c:pt>
                <c:pt idx="54">
                  <c:v>0.20444349999999911</c:v>
                </c:pt>
                <c:pt idx="55">
                  <c:v>0.24273975000000014</c:v>
                </c:pt>
                <c:pt idx="56">
                  <c:v>0.1603374999999998</c:v>
                </c:pt>
                <c:pt idx="57">
                  <c:v>0.28702525000000101</c:v>
                </c:pt>
                <c:pt idx="58">
                  <c:v>0.25962400000000052</c:v>
                </c:pt>
                <c:pt idx="59">
                  <c:v>0.27189400000000141</c:v>
                </c:pt>
                <c:pt idx="60">
                  <c:v>0.5052082500000008</c:v>
                </c:pt>
                <c:pt idx="61">
                  <c:v>0.70379025000000262</c:v>
                </c:pt>
                <c:pt idx="62">
                  <c:v>0.11465100000000028</c:v>
                </c:pt>
                <c:pt idx="63">
                  <c:v>0.2446725000000054</c:v>
                </c:pt>
                <c:pt idx="64">
                  <c:v>6.4003499999998326E-2</c:v>
                </c:pt>
                <c:pt idx="65">
                  <c:v>0.62876025000000002</c:v>
                </c:pt>
                <c:pt idx="66">
                  <c:v>7.0175000000001653E-2</c:v>
                </c:pt>
                <c:pt idx="67">
                  <c:v>-4.955075000000031E-2</c:v>
                </c:pt>
                <c:pt idx="68">
                  <c:v>0.35675100000000093</c:v>
                </c:pt>
                <c:pt idx="69">
                  <c:v>-0.20005550000000039</c:v>
                </c:pt>
                <c:pt idx="70">
                  <c:v>0.12048324999999949</c:v>
                </c:pt>
                <c:pt idx="71">
                  <c:v>1.9356499999998888E-2</c:v>
                </c:pt>
                <c:pt idx="72">
                  <c:v>0.2443925000000009</c:v>
                </c:pt>
                <c:pt idx="73">
                  <c:v>0.19168249999999887</c:v>
                </c:pt>
                <c:pt idx="74">
                  <c:v>3.4629749999998793E-2</c:v>
                </c:pt>
                <c:pt idx="75">
                  <c:v>0.23013300000000214</c:v>
                </c:pt>
                <c:pt idx="76">
                  <c:v>0.76129025000000006</c:v>
                </c:pt>
                <c:pt idx="77">
                  <c:v>6.2599000000002292E-2</c:v>
                </c:pt>
                <c:pt idx="78">
                  <c:v>0.18648349999999958</c:v>
                </c:pt>
                <c:pt idx="79">
                  <c:v>0.23452124999999668</c:v>
                </c:pt>
                <c:pt idx="80">
                  <c:v>0.26183999999999941</c:v>
                </c:pt>
                <c:pt idx="81">
                  <c:v>0.83643599999999996</c:v>
                </c:pt>
                <c:pt idx="82">
                  <c:v>0.94916425000000038</c:v>
                </c:pt>
                <c:pt idx="83">
                  <c:v>0.2192847499999997</c:v>
                </c:pt>
                <c:pt idx="84">
                  <c:v>9.135599999999755E-2</c:v>
                </c:pt>
                <c:pt idx="85">
                  <c:v>0.2761127500000029</c:v>
                </c:pt>
                <c:pt idx="86">
                  <c:v>0.29689249999999845</c:v>
                </c:pt>
                <c:pt idx="87">
                  <c:v>0.25685950000000002</c:v>
                </c:pt>
                <c:pt idx="88">
                  <c:v>0.20614799999999889</c:v>
                </c:pt>
                <c:pt idx="89">
                  <c:v>0.52668374999999834</c:v>
                </c:pt>
                <c:pt idx="90">
                  <c:v>0.23110374999999728</c:v>
                </c:pt>
                <c:pt idx="91">
                  <c:v>0.22417450000000017</c:v>
                </c:pt>
                <c:pt idx="92">
                  <c:v>0.29962375000000385</c:v>
                </c:pt>
                <c:pt idx="93">
                  <c:v>0.23589800000000238</c:v>
                </c:pt>
                <c:pt idx="94">
                  <c:v>9.3440250000001335E-2</c:v>
                </c:pt>
                <c:pt idx="95">
                  <c:v>5.7585250000000254E-2</c:v>
                </c:pt>
                <c:pt idx="96">
                  <c:v>3.7957249999999831E-2</c:v>
                </c:pt>
                <c:pt idx="97">
                  <c:v>0.27059949999999988</c:v>
                </c:pt>
                <c:pt idx="98">
                  <c:v>-0.12285899999999916</c:v>
                </c:pt>
                <c:pt idx="99">
                  <c:v>0.28621650000000098</c:v>
                </c:pt>
                <c:pt idx="100">
                  <c:v>0.26617774999999888</c:v>
                </c:pt>
                <c:pt idx="101">
                  <c:v>7.8693499999999972E-2</c:v>
                </c:pt>
                <c:pt idx="102">
                  <c:v>9.8524999999996865E-2</c:v>
                </c:pt>
                <c:pt idx="103">
                  <c:v>0.15286175000000135</c:v>
                </c:pt>
                <c:pt idx="104">
                  <c:v>0.37914100000000239</c:v>
                </c:pt>
                <c:pt idx="105">
                  <c:v>0.17302175000000197</c:v>
                </c:pt>
                <c:pt idx="106">
                  <c:v>1.3107749999998752E-2</c:v>
                </c:pt>
                <c:pt idx="107">
                  <c:v>8.66680000000013E-2</c:v>
                </c:pt>
                <c:pt idx="108">
                  <c:v>0.41610474999999969</c:v>
                </c:pt>
                <c:pt idx="109">
                  <c:v>0.64304950000000005</c:v>
                </c:pt>
                <c:pt idx="110">
                  <c:v>0.28892500000000254</c:v>
                </c:pt>
                <c:pt idx="111">
                  <c:v>0.16197675000000444</c:v>
                </c:pt>
                <c:pt idx="112">
                  <c:v>0.10583875000000065</c:v>
                </c:pt>
                <c:pt idx="113">
                  <c:v>-0.10920125000000003</c:v>
                </c:pt>
                <c:pt idx="114">
                  <c:v>0.45876375000000102</c:v>
                </c:pt>
                <c:pt idx="115">
                  <c:v>0.16969049999999986</c:v>
                </c:pt>
                <c:pt idx="116">
                  <c:v>1.0220249999998821E-2</c:v>
                </c:pt>
                <c:pt idx="117">
                  <c:v>0.16986849999999798</c:v>
                </c:pt>
                <c:pt idx="118">
                  <c:v>-0.16819174999999997</c:v>
                </c:pt>
                <c:pt idx="119">
                  <c:v>0.13149550000000043</c:v>
                </c:pt>
                <c:pt idx="120">
                  <c:v>0.17054750000000052</c:v>
                </c:pt>
                <c:pt idx="121">
                  <c:v>-8.7789499999999965E-2</c:v>
                </c:pt>
                <c:pt idx="122">
                  <c:v>0.17819575000000087</c:v>
                </c:pt>
                <c:pt idx="123">
                  <c:v>0.21708049999999979</c:v>
                </c:pt>
                <c:pt idx="124">
                  <c:v>0.19316250000000235</c:v>
                </c:pt>
                <c:pt idx="125">
                  <c:v>7.8093500000003147E-2</c:v>
                </c:pt>
                <c:pt idx="126">
                  <c:v>9.0912500000003504E-2</c:v>
                </c:pt>
                <c:pt idx="127">
                  <c:v>9.0941000000002603E-2</c:v>
                </c:pt>
                <c:pt idx="128">
                  <c:v>0.16078275000000275</c:v>
                </c:pt>
                <c:pt idx="129">
                  <c:v>0.23528500000000019</c:v>
                </c:pt>
                <c:pt idx="130">
                  <c:v>-8.5773000000001431E-2</c:v>
                </c:pt>
                <c:pt idx="131">
                  <c:v>2.3919999999999497E-2</c:v>
                </c:pt>
                <c:pt idx="132">
                  <c:v>-3.5644500000000967E-2</c:v>
                </c:pt>
                <c:pt idx="133">
                  <c:v>-1.7144500000000118E-2</c:v>
                </c:pt>
                <c:pt idx="134">
                  <c:v>-3.4345999999999988E-2</c:v>
                </c:pt>
                <c:pt idx="135">
                  <c:v>0.19897650000000006</c:v>
                </c:pt>
                <c:pt idx="136">
                  <c:v>-0.10082675000000002</c:v>
                </c:pt>
                <c:pt idx="137">
                  <c:v>-0.20481974999999952</c:v>
                </c:pt>
                <c:pt idx="138">
                  <c:v>0.27419774999999635</c:v>
                </c:pt>
                <c:pt idx="139">
                  <c:v>5.507300000000015E-2</c:v>
                </c:pt>
                <c:pt idx="140">
                  <c:v>2.8249000000000007E-2</c:v>
                </c:pt>
                <c:pt idx="141">
                  <c:v>-8.8539000000000034E-2</c:v>
                </c:pt>
                <c:pt idx="142">
                  <c:v>-0.16237550000000012</c:v>
                </c:pt>
                <c:pt idx="143">
                  <c:v>0.11224849999999931</c:v>
                </c:pt>
                <c:pt idx="144">
                  <c:v>9.7457000000000182E-2</c:v>
                </c:pt>
                <c:pt idx="145">
                  <c:v>0.49547950000000052</c:v>
                </c:pt>
                <c:pt idx="146">
                  <c:v>0.5054522499999976</c:v>
                </c:pt>
                <c:pt idx="147">
                  <c:v>-6.4047750000003845E-2</c:v>
                </c:pt>
                <c:pt idx="148">
                  <c:v>0.21765175000000014</c:v>
                </c:pt>
                <c:pt idx="149">
                  <c:v>0.38943849999999713</c:v>
                </c:pt>
                <c:pt idx="150">
                  <c:v>1.0106250000001094E-2</c:v>
                </c:pt>
                <c:pt idx="151">
                  <c:v>0.17301950000000232</c:v>
                </c:pt>
                <c:pt idx="152">
                  <c:v>0.29758699999999916</c:v>
                </c:pt>
                <c:pt idx="153">
                  <c:v>0.70506850000000298</c:v>
                </c:pt>
                <c:pt idx="154">
                  <c:v>0.15497824999999832</c:v>
                </c:pt>
                <c:pt idx="155">
                  <c:v>0.20838100000000015</c:v>
                </c:pt>
                <c:pt idx="156">
                  <c:v>-4.0030000000000676E-2</c:v>
                </c:pt>
                <c:pt idx="157">
                  <c:v>-1.8333499999999781E-2</c:v>
                </c:pt>
                <c:pt idx="158">
                  <c:v>-0.12124725000000014</c:v>
                </c:pt>
                <c:pt idx="159">
                  <c:v>0.12150350000000021</c:v>
                </c:pt>
                <c:pt idx="160">
                  <c:v>0.41181224999999877</c:v>
                </c:pt>
                <c:pt idx="161">
                  <c:v>0.2181367500000011</c:v>
                </c:pt>
                <c:pt idx="162">
                  <c:v>9.1343749999999613E-2</c:v>
                </c:pt>
                <c:pt idx="163">
                  <c:v>7.0329749999999081E-2</c:v>
                </c:pt>
                <c:pt idx="164">
                  <c:v>-0.14219725000000061</c:v>
                </c:pt>
                <c:pt idx="165">
                  <c:v>0.1569912500000008</c:v>
                </c:pt>
                <c:pt idx="166">
                  <c:v>0.19033650000000257</c:v>
                </c:pt>
                <c:pt idx="167">
                  <c:v>0.32811024999999994</c:v>
                </c:pt>
                <c:pt idx="168">
                  <c:v>0.2191624999999997</c:v>
                </c:pt>
                <c:pt idx="169">
                  <c:v>0.19344874999999639</c:v>
                </c:pt>
                <c:pt idx="170">
                  <c:v>0.14746999999999932</c:v>
                </c:pt>
                <c:pt idx="171">
                  <c:v>0.24031575000000238</c:v>
                </c:pt>
                <c:pt idx="172">
                  <c:v>0.38266175000000224</c:v>
                </c:pt>
                <c:pt idx="173">
                  <c:v>0.12516274999999943</c:v>
                </c:pt>
                <c:pt idx="174">
                  <c:v>0.27636975000000064</c:v>
                </c:pt>
                <c:pt idx="175">
                  <c:v>0.22826299999999877</c:v>
                </c:pt>
                <c:pt idx="176">
                  <c:v>-0.21741924999999984</c:v>
                </c:pt>
                <c:pt idx="177">
                  <c:v>0.1848685000000021</c:v>
                </c:pt>
                <c:pt idx="178">
                  <c:v>0.31562049999999786</c:v>
                </c:pt>
                <c:pt idx="179">
                  <c:v>0.31348774999999929</c:v>
                </c:pt>
                <c:pt idx="180">
                  <c:v>1.4135999999998816E-2</c:v>
                </c:pt>
                <c:pt idx="181">
                  <c:v>0.17383499999999774</c:v>
                </c:pt>
                <c:pt idx="182">
                  <c:v>-3.0002000000000001E-2</c:v>
                </c:pt>
                <c:pt idx="183">
                  <c:v>0.17649675000000054</c:v>
                </c:pt>
                <c:pt idx="184">
                  <c:v>1.0290324999999987</c:v>
                </c:pt>
                <c:pt idx="185">
                  <c:v>0.3511042499999979</c:v>
                </c:pt>
                <c:pt idx="186">
                  <c:v>0.3729260000000032</c:v>
                </c:pt>
                <c:pt idx="187">
                  <c:v>0.48194800000000271</c:v>
                </c:pt>
                <c:pt idx="188">
                  <c:v>0.2880780000000005</c:v>
                </c:pt>
                <c:pt idx="189">
                  <c:v>0.3142864999999988</c:v>
                </c:pt>
                <c:pt idx="190">
                  <c:v>0.26914900000000008</c:v>
                </c:pt>
                <c:pt idx="191">
                  <c:v>0.14964175000000068</c:v>
                </c:pt>
                <c:pt idx="192">
                  <c:v>0.30750350000000193</c:v>
                </c:pt>
                <c:pt idx="193">
                  <c:v>0.26254399999999967</c:v>
                </c:pt>
                <c:pt idx="194">
                  <c:v>0.24597349999999985</c:v>
                </c:pt>
                <c:pt idx="195">
                  <c:v>0.1064105000000044</c:v>
                </c:pt>
                <c:pt idx="196">
                  <c:v>0.19236599999999981</c:v>
                </c:pt>
                <c:pt idx="197">
                  <c:v>9.6531999999998952E-2</c:v>
                </c:pt>
                <c:pt idx="198">
                  <c:v>0.16670475000000007</c:v>
                </c:pt>
                <c:pt idx="199">
                  <c:v>8.075774999999652E-2</c:v>
                </c:pt>
                <c:pt idx="200">
                  <c:v>0.30984174999999681</c:v>
                </c:pt>
                <c:pt idx="201">
                  <c:v>0.13975099999999951</c:v>
                </c:pt>
                <c:pt idx="202">
                  <c:v>4.8367250000000972E-2</c:v>
                </c:pt>
                <c:pt idx="203">
                  <c:v>0.25756674999999873</c:v>
                </c:pt>
                <c:pt idx="204">
                  <c:v>-3.7939500000000237E-2</c:v>
                </c:pt>
                <c:pt idx="205">
                  <c:v>0.10383649999999989</c:v>
                </c:pt>
                <c:pt idx="206">
                  <c:v>8.5197749999998962E-2</c:v>
                </c:pt>
                <c:pt idx="207">
                  <c:v>0.17118199999999817</c:v>
                </c:pt>
                <c:pt idx="208">
                  <c:v>0.2817729999999985</c:v>
                </c:pt>
                <c:pt idx="209">
                  <c:v>5.9830000000014039E-3</c:v>
                </c:pt>
                <c:pt idx="210">
                  <c:v>0.225629249999999</c:v>
                </c:pt>
                <c:pt idx="211">
                  <c:v>0.31939100000000487</c:v>
                </c:pt>
                <c:pt idx="212">
                  <c:v>6.715325000000405E-2</c:v>
                </c:pt>
                <c:pt idx="213">
                  <c:v>0.21943950000000001</c:v>
                </c:pt>
                <c:pt idx="214">
                  <c:v>0.30179774999999864</c:v>
                </c:pt>
                <c:pt idx="215">
                  <c:v>-8.0392249999999166E-2</c:v>
                </c:pt>
                <c:pt idx="216">
                  <c:v>-6.7155500000005475E-2</c:v>
                </c:pt>
                <c:pt idx="217">
                  <c:v>0.56878224999999993</c:v>
                </c:pt>
                <c:pt idx="218">
                  <c:v>2.3510750000001579E-2</c:v>
                </c:pt>
                <c:pt idx="219">
                  <c:v>0.25698399999999921</c:v>
                </c:pt>
                <c:pt idx="220">
                  <c:v>-0.29154150000000012</c:v>
                </c:pt>
                <c:pt idx="221">
                  <c:v>9.3046250000001329E-2</c:v>
                </c:pt>
                <c:pt idx="222">
                  <c:v>0.16842099999999993</c:v>
                </c:pt>
                <c:pt idx="223">
                  <c:v>2.9405750000000008E-2</c:v>
                </c:pt>
                <c:pt idx="224">
                  <c:v>0.22806250000000006</c:v>
                </c:pt>
                <c:pt idx="225">
                  <c:v>2.1434999999994986E-2</c:v>
                </c:pt>
                <c:pt idx="226">
                  <c:v>0.15003875000000022</c:v>
                </c:pt>
                <c:pt idx="227">
                  <c:v>0.30189024999999958</c:v>
                </c:pt>
                <c:pt idx="228">
                  <c:v>0.11437974999999945</c:v>
                </c:pt>
                <c:pt idx="229">
                  <c:v>-3.8676500000001113E-2</c:v>
                </c:pt>
                <c:pt idx="230">
                  <c:v>7.7260750000000655E-2</c:v>
                </c:pt>
                <c:pt idx="231">
                  <c:v>0.54896574999999892</c:v>
                </c:pt>
                <c:pt idx="232">
                  <c:v>0.20705324999999863</c:v>
                </c:pt>
                <c:pt idx="233">
                  <c:v>-0.18112900000000054</c:v>
                </c:pt>
                <c:pt idx="234">
                  <c:v>7.0406750000000073E-2</c:v>
                </c:pt>
                <c:pt idx="235">
                  <c:v>0.37238550000000092</c:v>
                </c:pt>
                <c:pt idx="236">
                  <c:v>0.14153124999999633</c:v>
                </c:pt>
                <c:pt idx="237">
                  <c:v>0.27539449999999954</c:v>
                </c:pt>
                <c:pt idx="238">
                  <c:v>0.28241774999999691</c:v>
                </c:pt>
                <c:pt idx="239">
                  <c:v>2.8862499999998903E-2</c:v>
                </c:pt>
                <c:pt idx="240">
                  <c:v>3.5182499999999894E-2</c:v>
                </c:pt>
                <c:pt idx="241">
                  <c:v>9.1209250000001241E-2</c:v>
                </c:pt>
                <c:pt idx="242">
                  <c:v>0.34305899999999756</c:v>
                </c:pt>
                <c:pt idx="243">
                  <c:v>-0.16005300000000222</c:v>
                </c:pt>
                <c:pt idx="244">
                  <c:v>6.1405000000004151E-2</c:v>
                </c:pt>
                <c:pt idx="245">
                  <c:v>0.23774325000000074</c:v>
                </c:pt>
                <c:pt idx="246">
                  <c:v>6.8671000000000149E-2</c:v>
                </c:pt>
                <c:pt idx="247">
                  <c:v>0.189801000000001</c:v>
                </c:pt>
                <c:pt idx="248">
                  <c:v>0.31701075000000145</c:v>
                </c:pt>
                <c:pt idx="249">
                  <c:v>0.36850900000000042</c:v>
                </c:pt>
                <c:pt idx="250">
                  <c:v>3.6597999999999686E-2</c:v>
                </c:pt>
                <c:pt idx="251">
                  <c:v>0.2282637499999991</c:v>
                </c:pt>
                <c:pt idx="252">
                  <c:v>0.20057300000000122</c:v>
                </c:pt>
                <c:pt idx="253">
                  <c:v>0.28093074999999956</c:v>
                </c:pt>
                <c:pt idx="254">
                  <c:v>0.26883049999999997</c:v>
                </c:pt>
                <c:pt idx="255">
                  <c:v>0.27621125000000113</c:v>
                </c:pt>
                <c:pt idx="256">
                  <c:v>0.42283000000000204</c:v>
                </c:pt>
                <c:pt idx="257">
                  <c:v>0.34554849999999959</c:v>
                </c:pt>
                <c:pt idx="258">
                  <c:v>-8.004500000000192E-3</c:v>
                </c:pt>
                <c:pt idx="259">
                  <c:v>0.23649349999999991</c:v>
                </c:pt>
                <c:pt idx="260">
                  <c:v>-0.27107949999999903</c:v>
                </c:pt>
                <c:pt idx="261">
                  <c:v>0.13337149999999909</c:v>
                </c:pt>
                <c:pt idx="262">
                  <c:v>-0.13688499999999998</c:v>
                </c:pt>
                <c:pt idx="263">
                  <c:v>0.10972974999999963</c:v>
                </c:pt>
                <c:pt idx="264">
                  <c:v>0.17252649999999914</c:v>
                </c:pt>
                <c:pt idx="265">
                  <c:v>0.20994149999999401</c:v>
                </c:pt>
                <c:pt idx="266">
                  <c:v>0.34542100000000442</c:v>
                </c:pt>
                <c:pt idx="267">
                  <c:v>0.31447825000000584</c:v>
                </c:pt>
                <c:pt idx="268">
                  <c:v>0.23476699999999973</c:v>
                </c:pt>
                <c:pt idx="269">
                  <c:v>0.30918599999999952</c:v>
                </c:pt>
                <c:pt idx="270">
                  <c:v>0.30826950000000242</c:v>
                </c:pt>
                <c:pt idx="271">
                  <c:v>0.19185025000000167</c:v>
                </c:pt>
              </c:numCache>
            </c:numRef>
          </c:xVal>
          <c:yVal>
            <c:numRef>
              <c:f>'Q4vsQ1-K1volcano'!$H$6:$H$277</c:f>
              <c:numCache>
                <c:formatCode>General</c:formatCode>
                <c:ptCount val="272"/>
                <c:pt idx="0">
                  <c:v>0.96344776402825749</c:v>
                </c:pt>
                <c:pt idx="1">
                  <c:v>0.61090166375286681</c:v>
                </c:pt>
                <c:pt idx="2">
                  <c:v>0.5936766845924546</c:v>
                </c:pt>
                <c:pt idx="3">
                  <c:v>7.7207242057021092E-2</c:v>
                </c:pt>
                <c:pt idx="4">
                  <c:v>0.96344776402825749</c:v>
                </c:pt>
                <c:pt idx="5">
                  <c:v>0.76954468610095283</c:v>
                </c:pt>
                <c:pt idx="6">
                  <c:v>0.49138494682260647</c:v>
                </c:pt>
                <c:pt idx="7">
                  <c:v>8.9487630377092384E-2</c:v>
                </c:pt>
                <c:pt idx="8">
                  <c:v>9.646288744567838E-2</c:v>
                </c:pt>
                <c:pt idx="9">
                  <c:v>0.59844490371429182</c:v>
                </c:pt>
                <c:pt idx="10">
                  <c:v>0.39189436455647009</c:v>
                </c:pt>
                <c:pt idx="11">
                  <c:v>1.8622246042051951E-2</c:v>
                </c:pt>
                <c:pt idx="12">
                  <c:v>0.47516158705941525</c:v>
                </c:pt>
                <c:pt idx="13">
                  <c:v>0.5257492121508528</c:v>
                </c:pt>
                <c:pt idx="14">
                  <c:v>0.14875625655588423</c:v>
                </c:pt>
                <c:pt idx="15">
                  <c:v>0.82002734140878142</c:v>
                </c:pt>
                <c:pt idx="16">
                  <c:v>0.7991028417502104</c:v>
                </c:pt>
                <c:pt idx="17">
                  <c:v>0.9447552628325514</c:v>
                </c:pt>
                <c:pt idx="18">
                  <c:v>0.61699417565621861</c:v>
                </c:pt>
                <c:pt idx="19">
                  <c:v>0.1797505635387153</c:v>
                </c:pt>
                <c:pt idx="20">
                  <c:v>0.17434023683259739</c:v>
                </c:pt>
                <c:pt idx="21">
                  <c:v>0.72920824549928509</c:v>
                </c:pt>
                <c:pt idx="22">
                  <c:v>0.30360847287657744</c:v>
                </c:pt>
                <c:pt idx="23">
                  <c:v>0.35817417331528456</c:v>
                </c:pt>
                <c:pt idx="24">
                  <c:v>0.72920824549928509</c:v>
                </c:pt>
                <c:pt idx="25">
                  <c:v>0.1797505635387153</c:v>
                </c:pt>
                <c:pt idx="26">
                  <c:v>0.38042552211267577</c:v>
                </c:pt>
                <c:pt idx="27">
                  <c:v>0.64137827618853016</c:v>
                </c:pt>
                <c:pt idx="28">
                  <c:v>0.41953643874705854</c:v>
                </c:pt>
                <c:pt idx="29">
                  <c:v>0.42787024243248389</c:v>
                </c:pt>
                <c:pt idx="30">
                  <c:v>0.76126037159534632</c:v>
                </c:pt>
                <c:pt idx="31">
                  <c:v>0.7991028417502104</c:v>
                </c:pt>
                <c:pt idx="32">
                  <c:v>1.0096708456177574</c:v>
                </c:pt>
                <c:pt idx="33">
                  <c:v>0.74803758321407077</c:v>
                </c:pt>
                <c:pt idx="34">
                  <c:v>9.4511556863226806E-2</c:v>
                </c:pt>
                <c:pt idx="35">
                  <c:v>0.77443129038912706</c:v>
                </c:pt>
                <c:pt idx="36">
                  <c:v>0.97199993421110842</c:v>
                </c:pt>
                <c:pt idx="37">
                  <c:v>0.12030174965158867</c:v>
                </c:pt>
                <c:pt idx="38">
                  <c:v>0.44620977212993201</c:v>
                </c:pt>
                <c:pt idx="39">
                  <c:v>0.19545110118343834</c:v>
                </c:pt>
                <c:pt idx="40">
                  <c:v>0.19304210913890268</c:v>
                </c:pt>
                <c:pt idx="41">
                  <c:v>0.41499466698736959</c:v>
                </c:pt>
                <c:pt idx="42">
                  <c:v>0.42787024243248389</c:v>
                </c:pt>
                <c:pt idx="43">
                  <c:v>0.5257492121508528</c:v>
                </c:pt>
                <c:pt idx="44">
                  <c:v>0.39125815584607221</c:v>
                </c:pt>
                <c:pt idx="45">
                  <c:v>0.61699417565621861</c:v>
                </c:pt>
                <c:pt idx="46">
                  <c:v>0.76937819288501186</c:v>
                </c:pt>
                <c:pt idx="47">
                  <c:v>0.16926300049410048</c:v>
                </c:pt>
                <c:pt idx="48">
                  <c:v>2.237678696441163E-2</c:v>
                </c:pt>
                <c:pt idx="49">
                  <c:v>4.9812437350896514E-2</c:v>
                </c:pt>
                <c:pt idx="50">
                  <c:v>0.77443129038912706</c:v>
                </c:pt>
                <c:pt idx="51">
                  <c:v>0.20065873919541677</c:v>
                </c:pt>
                <c:pt idx="52">
                  <c:v>0.81738024829957867</c:v>
                </c:pt>
                <c:pt idx="53">
                  <c:v>0.20065873919541677</c:v>
                </c:pt>
                <c:pt idx="54">
                  <c:v>0.5646563117455542</c:v>
                </c:pt>
                <c:pt idx="55">
                  <c:v>0.81667694420774151</c:v>
                </c:pt>
                <c:pt idx="56">
                  <c:v>0.68673225559050488</c:v>
                </c:pt>
                <c:pt idx="57">
                  <c:v>0.76937819288501186</c:v>
                </c:pt>
                <c:pt idx="58">
                  <c:v>0.50542669855504074</c:v>
                </c:pt>
                <c:pt idx="59">
                  <c:v>0.51868090083777341</c:v>
                </c:pt>
                <c:pt idx="60">
                  <c:v>0.89610134346415782</c:v>
                </c:pt>
                <c:pt idx="61">
                  <c:v>1.2022630344788352</c:v>
                </c:pt>
                <c:pt idx="62">
                  <c:v>0.41499466698736959</c:v>
                </c:pt>
                <c:pt idx="63">
                  <c:v>0.22716553512269824</c:v>
                </c:pt>
                <c:pt idx="64">
                  <c:v>0.10494558930711105</c:v>
                </c:pt>
                <c:pt idx="65">
                  <c:v>1.1816322089348557</c:v>
                </c:pt>
                <c:pt idx="66">
                  <c:v>0.24327010595179757</c:v>
                </c:pt>
                <c:pt idx="67">
                  <c:v>7.7207242057021092E-2</c:v>
                </c:pt>
                <c:pt idx="68">
                  <c:v>0.9447552628325514</c:v>
                </c:pt>
                <c:pt idx="69">
                  <c:v>0.3189173923107908</c:v>
                </c:pt>
                <c:pt idx="70">
                  <c:v>0.62709645757529786</c:v>
                </c:pt>
                <c:pt idx="71">
                  <c:v>0.10494558930711105</c:v>
                </c:pt>
                <c:pt idx="72">
                  <c:v>0.55316147988293829</c:v>
                </c:pt>
                <c:pt idx="73">
                  <c:v>0.25042980770593204</c:v>
                </c:pt>
                <c:pt idx="74">
                  <c:v>8.9487630377092384E-2</c:v>
                </c:pt>
                <c:pt idx="75">
                  <c:v>0.31858889970550558</c:v>
                </c:pt>
                <c:pt idx="76">
                  <c:v>0.92038049444265591</c:v>
                </c:pt>
                <c:pt idx="77">
                  <c:v>0.17423121434387312</c:v>
                </c:pt>
                <c:pt idx="78">
                  <c:v>0.27245034271409396</c:v>
                </c:pt>
                <c:pt idx="79">
                  <c:v>0.1797505635387153</c:v>
                </c:pt>
                <c:pt idx="80">
                  <c:v>0.21480137383351428</c:v>
                </c:pt>
                <c:pt idx="81">
                  <c:v>0.74803758321407077</c:v>
                </c:pt>
                <c:pt idx="82">
                  <c:v>0.76937819288501186</c:v>
                </c:pt>
                <c:pt idx="83">
                  <c:v>0.82002734140878142</c:v>
                </c:pt>
                <c:pt idx="84">
                  <c:v>0.21480137383351428</c:v>
                </c:pt>
                <c:pt idx="85">
                  <c:v>0.97924548028261937</c:v>
                </c:pt>
                <c:pt idx="86">
                  <c:v>1.2022630344788352</c:v>
                </c:pt>
                <c:pt idx="87">
                  <c:v>0.5936766845924546</c:v>
                </c:pt>
                <c:pt idx="88">
                  <c:v>1.0538813969651655</c:v>
                </c:pt>
                <c:pt idx="89">
                  <c:v>0.97924548028261937</c:v>
                </c:pt>
                <c:pt idx="90">
                  <c:v>0.5257492121508528</c:v>
                </c:pt>
                <c:pt idx="91">
                  <c:v>0.64015188270606993</c:v>
                </c:pt>
                <c:pt idx="92">
                  <c:v>0.28166205944307943</c:v>
                </c:pt>
                <c:pt idx="93">
                  <c:v>0.25916079134338849</c:v>
                </c:pt>
                <c:pt idx="94">
                  <c:v>0.18007171058955793</c:v>
                </c:pt>
                <c:pt idx="95">
                  <c:v>0.1256999437394912</c:v>
                </c:pt>
                <c:pt idx="96">
                  <c:v>9.4511556863226806E-2</c:v>
                </c:pt>
                <c:pt idx="97">
                  <c:v>0.64377781189262295</c:v>
                </c:pt>
                <c:pt idx="98">
                  <c:v>8.5350517632455603E-2</c:v>
                </c:pt>
                <c:pt idx="99">
                  <c:v>0.91027224335348933</c:v>
                </c:pt>
                <c:pt idx="100">
                  <c:v>0.53117101474540818</c:v>
                </c:pt>
                <c:pt idx="101">
                  <c:v>0.26784751866179601</c:v>
                </c:pt>
                <c:pt idx="102">
                  <c:v>0.63743772264134424</c:v>
                </c:pt>
                <c:pt idx="103">
                  <c:v>0.50864100700864556</c:v>
                </c:pt>
                <c:pt idx="104">
                  <c:v>0.5646563117455542</c:v>
                </c:pt>
                <c:pt idx="105">
                  <c:v>0.1256999437394912</c:v>
                </c:pt>
                <c:pt idx="106">
                  <c:v>3.6101821916307036E-2</c:v>
                </c:pt>
                <c:pt idx="107">
                  <c:v>0.20065873919541677</c:v>
                </c:pt>
                <c:pt idx="108">
                  <c:v>0.50426665973349927</c:v>
                </c:pt>
                <c:pt idx="109">
                  <c:v>1.1098253865640244</c:v>
                </c:pt>
                <c:pt idx="110">
                  <c:v>0.63974975264703327</c:v>
                </c:pt>
                <c:pt idx="111">
                  <c:v>0.27740968043255693</c:v>
                </c:pt>
                <c:pt idx="112">
                  <c:v>0.19545110118343834</c:v>
                </c:pt>
                <c:pt idx="113">
                  <c:v>0.2085082960595028</c:v>
                </c:pt>
                <c:pt idx="114">
                  <c:v>0.7991028417502104</c:v>
                </c:pt>
                <c:pt idx="115">
                  <c:v>0.18007171058955793</c:v>
                </c:pt>
                <c:pt idx="116">
                  <c:v>2.9743845662334543E-2</c:v>
                </c:pt>
                <c:pt idx="117">
                  <c:v>0.28035428789112737</c:v>
                </c:pt>
                <c:pt idx="118">
                  <c:v>0.24327010595179757</c:v>
                </c:pt>
                <c:pt idx="119">
                  <c:v>0.41953643874705854</c:v>
                </c:pt>
                <c:pt idx="120">
                  <c:v>0.41499466698736959</c:v>
                </c:pt>
                <c:pt idx="121">
                  <c:v>0.10620214791634489</c:v>
                </c:pt>
                <c:pt idx="122">
                  <c:v>0.23566510606685909</c:v>
                </c:pt>
                <c:pt idx="123">
                  <c:v>0.96344776402825749</c:v>
                </c:pt>
                <c:pt idx="124">
                  <c:v>0.61699417565621861</c:v>
                </c:pt>
                <c:pt idx="125">
                  <c:v>0.1797505635387153</c:v>
                </c:pt>
                <c:pt idx="126">
                  <c:v>0.20065873919541677</c:v>
                </c:pt>
                <c:pt idx="127">
                  <c:v>0.23816748142388472</c:v>
                </c:pt>
                <c:pt idx="128">
                  <c:v>0.51989295455106799</c:v>
                </c:pt>
                <c:pt idx="129">
                  <c:v>0.36335000567984677</c:v>
                </c:pt>
                <c:pt idx="130">
                  <c:v>0.22242840642828077</c:v>
                </c:pt>
                <c:pt idx="131">
                  <c:v>4.9812437350896514E-2</c:v>
                </c:pt>
                <c:pt idx="132">
                  <c:v>9.4511556863226806E-2</c:v>
                </c:pt>
                <c:pt idx="133">
                  <c:v>4.4902042952324035E-2</c:v>
                </c:pt>
                <c:pt idx="134">
                  <c:v>5.6155967646502505E-2</c:v>
                </c:pt>
                <c:pt idx="135">
                  <c:v>0.38693047587069324</c:v>
                </c:pt>
                <c:pt idx="136">
                  <c:v>0.10596647092775613</c:v>
                </c:pt>
                <c:pt idx="137">
                  <c:v>0.26784751866179601</c:v>
                </c:pt>
                <c:pt idx="138">
                  <c:v>0.96344776402825749</c:v>
                </c:pt>
                <c:pt idx="139">
                  <c:v>8.4166972039150217E-2</c:v>
                </c:pt>
                <c:pt idx="140">
                  <c:v>4.5163227216910649E-2</c:v>
                </c:pt>
                <c:pt idx="141">
                  <c:v>0.2357034028636773</c:v>
                </c:pt>
                <c:pt idx="142">
                  <c:v>0.25916079134338849</c:v>
                </c:pt>
                <c:pt idx="143">
                  <c:v>0.22789556779991291</c:v>
                </c:pt>
                <c:pt idx="144">
                  <c:v>8.4166972039150217E-2</c:v>
                </c:pt>
                <c:pt idx="145">
                  <c:v>0.70787470262302776</c:v>
                </c:pt>
                <c:pt idx="146">
                  <c:v>0.64137827618853016</c:v>
                </c:pt>
                <c:pt idx="147">
                  <c:v>0.2085082960595028</c:v>
                </c:pt>
                <c:pt idx="148">
                  <c:v>0.5646563117455542</c:v>
                </c:pt>
                <c:pt idx="149">
                  <c:v>0.61090166375286681</c:v>
                </c:pt>
                <c:pt idx="150">
                  <c:v>1.8622246042051951E-2</c:v>
                </c:pt>
                <c:pt idx="151">
                  <c:v>0.76954468610095283</c:v>
                </c:pt>
                <c:pt idx="152">
                  <c:v>0.74803758321407077</c:v>
                </c:pt>
                <c:pt idx="153">
                  <c:v>1.1901722942496809</c:v>
                </c:pt>
                <c:pt idx="154">
                  <c:v>0.64015188270606993</c:v>
                </c:pt>
                <c:pt idx="155">
                  <c:v>0.76937819288501186</c:v>
                </c:pt>
                <c:pt idx="156">
                  <c:v>7.9352795374114313E-2</c:v>
                </c:pt>
                <c:pt idx="157">
                  <c:v>1.8622246042051951E-2</c:v>
                </c:pt>
                <c:pt idx="158">
                  <c:v>0.26784751866179601</c:v>
                </c:pt>
                <c:pt idx="159">
                  <c:v>0.50864100700864556</c:v>
                </c:pt>
                <c:pt idx="160">
                  <c:v>1.2022630344788352</c:v>
                </c:pt>
                <c:pt idx="161">
                  <c:v>1.0948371781238053</c:v>
                </c:pt>
                <c:pt idx="162">
                  <c:v>0.19545110118343834</c:v>
                </c:pt>
                <c:pt idx="163">
                  <c:v>0.59253592160362312</c:v>
                </c:pt>
                <c:pt idx="164">
                  <c:v>0.19304210913890268</c:v>
                </c:pt>
                <c:pt idx="165">
                  <c:v>0.76126037159534632</c:v>
                </c:pt>
                <c:pt idx="166">
                  <c:v>0.82002734140878142</c:v>
                </c:pt>
                <c:pt idx="167">
                  <c:v>0.83132924945317122</c:v>
                </c:pt>
                <c:pt idx="168">
                  <c:v>0.40468699280801057</c:v>
                </c:pt>
                <c:pt idx="169">
                  <c:v>0.41499466698736959</c:v>
                </c:pt>
                <c:pt idx="170">
                  <c:v>0.42737253921823459</c:v>
                </c:pt>
                <c:pt idx="171">
                  <c:v>1.1006324692079705</c:v>
                </c:pt>
                <c:pt idx="172">
                  <c:v>0.50426665973349927</c:v>
                </c:pt>
                <c:pt idx="173">
                  <c:v>0.24197957756625024</c:v>
                </c:pt>
                <c:pt idx="174">
                  <c:v>0.53188525913584261</c:v>
                </c:pt>
                <c:pt idx="175">
                  <c:v>0.82537576425741599</c:v>
                </c:pt>
                <c:pt idx="176">
                  <c:v>0.51868090083777341</c:v>
                </c:pt>
                <c:pt idx="177">
                  <c:v>0.96344776402825749</c:v>
                </c:pt>
                <c:pt idx="178">
                  <c:v>0.76126037159534632</c:v>
                </c:pt>
                <c:pt idx="179">
                  <c:v>1.1098253865640244</c:v>
                </c:pt>
                <c:pt idx="180">
                  <c:v>2.3950729471685667E-2</c:v>
                </c:pt>
                <c:pt idx="181">
                  <c:v>0.59844490371429182</c:v>
                </c:pt>
                <c:pt idx="182">
                  <c:v>4.9812437350896514E-2</c:v>
                </c:pt>
                <c:pt idx="183">
                  <c:v>0.345515262158065</c:v>
                </c:pt>
                <c:pt idx="184">
                  <c:v>1.1098253865640244</c:v>
                </c:pt>
                <c:pt idx="185">
                  <c:v>1.1816322089348557</c:v>
                </c:pt>
                <c:pt idx="186">
                  <c:v>1.2022630344788352</c:v>
                </c:pt>
                <c:pt idx="187">
                  <c:v>1.1816322089348557</c:v>
                </c:pt>
                <c:pt idx="188">
                  <c:v>0.64015188270606993</c:v>
                </c:pt>
                <c:pt idx="189">
                  <c:v>0.50864100700864556</c:v>
                </c:pt>
                <c:pt idx="190">
                  <c:v>0.61090166375286681</c:v>
                </c:pt>
                <c:pt idx="191">
                  <c:v>0.47516158705941525</c:v>
                </c:pt>
                <c:pt idx="192">
                  <c:v>0.59253592160362312</c:v>
                </c:pt>
                <c:pt idx="193">
                  <c:v>1.1098253865640244</c:v>
                </c:pt>
                <c:pt idx="194">
                  <c:v>0.30470196594709664</c:v>
                </c:pt>
                <c:pt idx="195">
                  <c:v>8.9487630377092384E-2</c:v>
                </c:pt>
                <c:pt idx="196">
                  <c:v>0.64015188270606993</c:v>
                </c:pt>
                <c:pt idx="197">
                  <c:v>0.21266947842364056</c:v>
                </c:pt>
                <c:pt idx="198">
                  <c:v>0.64015188270606993</c:v>
                </c:pt>
                <c:pt idx="199">
                  <c:v>0.2221148275375614</c:v>
                </c:pt>
                <c:pt idx="200">
                  <c:v>1.1006324692079705</c:v>
                </c:pt>
                <c:pt idx="201">
                  <c:v>0.22789556779991291</c:v>
                </c:pt>
                <c:pt idx="202">
                  <c:v>0.5936766845924546</c:v>
                </c:pt>
                <c:pt idx="203">
                  <c:v>1.1006324692079705</c:v>
                </c:pt>
                <c:pt idx="204">
                  <c:v>5.6155967646502505E-2</c:v>
                </c:pt>
                <c:pt idx="205">
                  <c:v>0.70787470262302776</c:v>
                </c:pt>
                <c:pt idx="206">
                  <c:v>0.26784751866179601</c:v>
                </c:pt>
                <c:pt idx="207">
                  <c:v>1.0796488702915219</c:v>
                </c:pt>
                <c:pt idx="208">
                  <c:v>0.7991028417502104</c:v>
                </c:pt>
                <c:pt idx="209">
                  <c:v>2.3950729471685667E-2</c:v>
                </c:pt>
                <c:pt idx="210">
                  <c:v>0.77443129038912706</c:v>
                </c:pt>
                <c:pt idx="211">
                  <c:v>1.0948371781238053</c:v>
                </c:pt>
                <c:pt idx="212">
                  <c:v>0.40468699280801057</c:v>
                </c:pt>
                <c:pt idx="213">
                  <c:v>0.47566418490188583</c:v>
                </c:pt>
                <c:pt idx="214">
                  <c:v>1.1006324692079705</c:v>
                </c:pt>
                <c:pt idx="215">
                  <c:v>0.10689523265821124</c:v>
                </c:pt>
                <c:pt idx="216">
                  <c:v>9.0356179507084133E-2</c:v>
                </c:pt>
                <c:pt idx="217">
                  <c:v>0.96344776402825749</c:v>
                </c:pt>
                <c:pt idx="218">
                  <c:v>4.4949854005000407E-2</c:v>
                </c:pt>
                <c:pt idx="219">
                  <c:v>0.7991028417502104</c:v>
                </c:pt>
                <c:pt idx="220">
                  <c:v>0.38708741999084145</c:v>
                </c:pt>
                <c:pt idx="221">
                  <c:v>0.2085082960595028</c:v>
                </c:pt>
                <c:pt idx="222">
                  <c:v>0.23507314394515014</c:v>
                </c:pt>
                <c:pt idx="223">
                  <c:v>4.5163227216910649E-2</c:v>
                </c:pt>
                <c:pt idx="224">
                  <c:v>0.4722454210127684</c:v>
                </c:pt>
                <c:pt idx="225">
                  <c:v>0.28166205944307943</c:v>
                </c:pt>
                <c:pt idx="226">
                  <c:v>1.1006324692079705</c:v>
                </c:pt>
                <c:pt idx="227">
                  <c:v>0.9447552628325514</c:v>
                </c:pt>
                <c:pt idx="228">
                  <c:v>1.0096708456177574</c:v>
                </c:pt>
                <c:pt idx="229">
                  <c:v>4.9812437350896514E-2</c:v>
                </c:pt>
                <c:pt idx="230">
                  <c:v>8.9487630377092384E-2</c:v>
                </c:pt>
                <c:pt idx="231">
                  <c:v>1.1006324692079705</c:v>
                </c:pt>
                <c:pt idx="232">
                  <c:v>0.55316147988293829</c:v>
                </c:pt>
                <c:pt idx="233">
                  <c:v>0.22985540529631335</c:v>
                </c:pt>
                <c:pt idx="234">
                  <c:v>0.3189173923107908</c:v>
                </c:pt>
                <c:pt idx="235">
                  <c:v>1.0096708456177574</c:v>
                </c:pt>
                <c:pt idx="236">
                  <c:v>0.5646563117455542</c:v>
                </c:pt>
                <c:pt idx="237">
                  <c:v>1.1006324692079705</c:v>
                </c:pt>
                <c:pt idx="238">
                  <c:v>0.8192209589921231</c:v>
                </c:pt>
                <c:pt idx="239">
                  <c:v>0.17434023683259739</c:v>
                </c:pt>
                <c:pt idx="240">
                  <c:v>8.9487630377092384E-2</c:v>
                </c:pt>
                <c:pt idx="241">
                  <c:v>0.51868090083777341</c:v>
                </c:pt>
                <c:pt idx="242">
                  <c:v>1.1006324692079705</c:v>
                </c:pt>
                <c:pt idx="243">
                  <c:v>0.48250142179811079</c:v>
                </c:pt>
                <c:pt idx="244">
                  <c:v>0.1797505635387153</c:v>
                </c:pt>
                <c:pt idx="245">
                  <c:v>0.64015188270606993</c:v>
                </c:pt>
                <c:pt idx="246">
                  <c:v>0.2085082960595028</c:v>
                </c:pt>
                <c:pt idx="247">
                  <c:v>0.44263478606653317</c:v>
                </c:pt>
                <c:pt idx="248">
                  <c:v>0.59444173635672493</c:v>
                </c:pt>
                <c:pt idx="249">
                  <c:v>1.2022630344788352</c:v>
                </c:pt>
                <c:pt idx="250">
                  <c:v>8.3115652287223563E-2</c:v>
                </c:pt>
                <c:pt idx="251">
                  <c:v>0.47516158705941525</c:v>
                </c:pt>
                <c:pt idx="252">
                  <c:v>0.57334617244229835</c:v>
                </c:pt>
                <c:pt idx="253">
                  <c:v>0.7991028417502104</c:v>
                </c:pt>
                <c:pt idx="254">
                  <c:v>0.64015188270606993</c:v>
                </c:pt>
                <c:pt idx="255">
                  <c:v>0.66683794238331817</c:v>
                </c:pt>
                <c:pt idx="256">
                  <c:v>1.1006324692079705</c:v>
                </c:pt>
                <c:pt idx="257">
                  <c:v>0.64137827618853016</c:v>
                </c:pt>
                <c:pt idx="258">
                  <c:v>2.9743845662334543E-2</c:v>
                </c:pt>
                <c:pt idx="259">
                  <c:v>0.40468699280801057</c:v>
                </c:pt>
                <c:pt idx="260">
                  <c:v>0.64137827618853016</c:v>
                </c:pt>
                <c:pt idx="261">
                  <c:v>0.32732296118946819</c:v>
                </c:pt>
                <c:pt idx="262">
                  <c:v>0.1797505635387153</c:v>
                </c:pt>
                <c:pt idx="263">
                  <c:v>0.44617781566296999</c:v>
                </c:pt>
                <c:pt idx="264">
                  <c:v>0.74803758321407077</c:v>
                </c:pt>
                <c:pt idx="265">
                  <c:v>0.97199993421110842</c:v>
                </c:pt>
                <c:pt idx="266">
                  <c:v>1.1098253865640244</c:v>
                </c:pt>
                <c:pt idx="267">
                  <c:v>1.1816322089348557</c:v>
                </c:pt>
                <c:pt idx="268">
                  <c:v>0.72920824549928509</c:v>
                </c:pt>
                <c:pt idx="269">
                  <c:v>0.82002734140878142</c:v>
                </c:pt>
                <c:pt idx="270">
                  <c:v>0.5646563117455542</c:v>
                </c:pt>
                <c:pt idx="271">
                  <c:v>0.508641007008645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933-493E-8BF3-503CA958E3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0147976"/>
        <c:axId val="600146336"/>
      </c:scatterChart>
      <c:scatterChart>
        <c:scatterStyle val="smoothMarker"/>
        <c:varyColors val="0"/>
        <c:ser>
          <c:idx val="2"/>
          <c:order val="2"/>
          <c:tx>
            <c:v>p-val</c:v>
          </c:tx>
          <c:spPr>
            <a:ln w="1270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Q4vsQ1-K1volcano'!$M$2:$M$3</c:f>
              <c:numCache>
                <c:formatCode>General</c:formatCode>
                <c:ptCount val="2"/>
                <c:pt idx="0">
                  <c:v>-0.4</c:v>
                </c:pt>
                <c:pt idx="1">
                  <c:v>1.2</c:v>
                </c:pt>
              </c:numCache>
            </c:numRef>
          </c:xVal>
          <c:yVal>
            <c:numRef>
              <c:f>'Q4vsQ1-K1volcano'!$N$2:$N$3</c:f>
              <c:numCache>
                <c:formatCode>General</c:formatCode>
                <c:ptCount val="2"/>
                <c:pt idx="0">
                  <c:v>1.3010299956639813</c:v>
                </c:pt>
                <c:pt idx="1">
                  <c:v>1.30102999566398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933-493E-8BF3-503CA958E3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0147976"/>
        <c:axId val="600146336"/>
      </c:scatterChart>
      <c:valAx>
        <c:axId val="600147976"/>
        <c:scaling>
          <c:orientation val="minMax"/>
          <c:max val="1.2"/>
          <c:min val="-0.4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log2 fold change (</a:t>
                </a:r>
                <a:r>
                  <a:rPr lang="cs-CZ" dirty="0"/>
                  <a:t>HF </a:t>
                </a:r>
                <a:r>
                  <a:rPr lang="cs-CZ" dirty="0" err="1"/>
                  <a:t>high</a:t>
                </a:r>
                <a:r>
                  <a:rPr lang="cs-CZ" baseline="0" dirty="0"/>
                  <a:t> PVR </a:t>
                </a:r>
                <a:r>
                  <a:rPr lang="en-US" dirty="0"/>
                  <a:t>vs </a:t>
                </a:r>
                <a:r>
                  <a:rPr lang="cs-CZ" dirty="0"/>
                  <a:t>HF </a:t>
                </a:r>
                <a:r>
                  <a:rPr lang="cs-CZ" dirty="0" err="1"/>
                  <a:t>low</a:t>
                </a:r>
                <a:r>
                  <a:rPr lang="cs-CZ" dirty="0"/>
                  <a:t> PVR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0.17270125430325645"/>
              <c:y val="0.93622067622667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0146336"/>
        <c:crosses val="autoZero"/>
        <c:crossBetween val="midCat"/>
      </c:valAx>
      <c:valAx>
        <c:axId val="6001463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10 FDR adj. P valu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0147976"/>
        <c:crossesAt val="-0.4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4125</cdr:x>
      <cdr:y>0.09393</cdr:y>
    </cdr:from>
    <cdr:to>
      <cdr:x>0.97314</cdr:x>
      <cdr:y>0.14155</cdr:y>
    </cdr:to>
    <cdr:sp macro="" textlink="">
      <cdr:nvSpPr>
        <cdr:cNvPr id="2" name="TextovéPole 1">
          <a:extLst xmlns:a="http://schemas.openxmlformats.org/drawingml/2006/main">
            <a:ext uri="{FF2B5EF4-FFF2-40B4-BE49-F238E27FC236}">
              <a16:creationId xmlns:a16="http://schemas.microsoft.com/office/drawing/2014/main" id="{D030D7BA-B47C-4CA8-9F4C-E0A9F64D852F}"/>
            </a:ext>
          </a:extLst>
        </cdr:cNvPr>
        <cdr:cNvSpPr txBox="1"/>
      </cdr:nvSpPr>
      <cdr:spPr>
        <a:xfrm xmlns:a="http://schemas.openxmlformats.org/drawingml/2006/main">
          <a:off x="5047500" y="338139"/>
          <a:ext cx="791325" cy="171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cs-CZ" sz="900" b="1">
              <a:latin typeface="Arial" panose="020B0604020202020204" pitchFamily="34" charset="0"/>
              <a:cs typeface="Arial" panose="020B0604020202020204" pitchFamily="34" charset="0"/>
            </a:rPr>
            <a:t>NT-proBNP</a:t>
          </a:r>
        </a:p>
      </cdr:txBody>
    </cdr:sp>
  </cdr:relSizeAnchor>
  <cdr:relSizeAnchor xmlns:cdr="http://schemas.openxmlformats.org/drawingml/2006/chartDrawing">
    <cdr:from>
      <cdr:x>0.89218</cdr:x>
      <cdr:y>0.14155</cdr:y>
    </cdr:from>
    <cdr:to>
      <cdr:x>0.90719</cdr:x>
      <cdr:y>0.19182</cdr:y>
    </cdr:to>
    <cdr:cxnSp macro="">
      <cdr:nvCxnSpPr>
        <cdr:cNvPr id="4" name="Přímá spojnice 3">
          <a:extLst xmlns:a="http://schemas.openxmlformats.org/drawingml/2006/main">
            <a:ext uri="{FF2B5EF4-FFF2-40B4-BE49-F238E27FC236}">
              <a16:creationId xmlns:a16="http://schemas.microsoft.com/office/drawing/2014/main" id="{367B6DF3-5563-4F12-BDBD-0B7AE4A7AFC5}"/>
            </a:ext>
          </a:extLst>
        </cdr:cNvPr>
        <cdr:cNvCxnSpPr>
          <a:stCxn xmlns:a="http://schemas.openxmlformats.org/drawingml/2006/main" id="2" idx="2"/>
        </cdr:cNvCxnSpPr>
      </cdr:nvCxnSpPr>
      <cdr:spPr>
        <a:xfrm xmlns:a="http://schemas.openxmlformats.org/drawingml/2006/main" flipH="1">
          <a:off x="5353050" y="509589"/>
          <a:ext cx="90113" cy="180974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0304</cdr:x>
      <cdr:y>0.22578</cdr:y>
    </cdr:from>
    <cdr:to>
      <cdr:x>0.97871</cdr:x>
      <cdr:y>0.27649</cdr:y>
    </cdr:to>
    <cdr:sp macro="" textlink="">
      <cdr:nvSpPr>
        <cdr:cNvPr id="7" name="TextovéPole 1">
          <a:extLst xmlns:a="http://schemas.openxmlformats.org/drawingml/2006/main">
            <a:ext uri="{FF2B5EF4-FFF2-40B4-BE49-F238E27FC236}">
              <a16:creationId xmlns:a16="http://schemas.microsoft.com/office/drawing/2014/main" id="{EACF43D1-1BCE-4551-94E0-6352F8D9F548}"/>
            </a:ext>
          </a:extLst>
        </cdr:cNvPr>
        <cdr:cNvSpPr txBox="1"/>
      </cdr:nvSpPr>
      <cdr:spPr>
        <a:xfrm xmlns:a="http://schemas.openxmlformats.org/drawingml/2006/main">
          <a:off x="5418225" y="812799"/>
          <a:ext cx="454025" cy="1825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>
              <a:latin typeface="Arial" panose="020B0604020202020204" pitchFamily="34" charset="0"/>
              <a:cs typeface="Arial" panose="020B0604020202020204" pitchFamily="34" charset="0"/>
            </a:rPr>
            <a:t>BNP</a:t>
          </a:r>
        </a:p>
      </cdr:txBody>
    </cdr:sp>
  </cdr:relSizeAnchor>
  <cdr:relSizeAnchor xmlns:cdr="http://schemas.openxmlformats.org/drawingml/2006/chartDrawing">
    <cdr:from>
      <cdr:x>0.93663</cdr:x>
      <cdr:y>0.27649</cdr:y>
    </cdr:from>
    <cdr:to>
      <cdr:x>0.94087</cdr:x>
      <cdr:y>0.31089</cdr:y>
    </cdr:to>
    <cdr:cxnSp macro="">
      <cdr:nvCxnSpPr>
        <cdr:cNvPr id="8" name="Přímá spojnice 7">
          <a:extLst xmlns:a="http://schemas.openxmlformats.org/drawingml/2006/main">
            <a:ext uri="{FF2B5EF4-FFF2-40B4-BE49-F238E27FC236}">
              <a16:creationId xmlns:a16="http://schemas.microsoft.com/office/drawing/2014/main" id="{DE406DCC-31A6-4B62-9C90-9DBE125DD600}"/>
            </a:ext>
          </a:extLst>
        </cdr:cNvPr>
        <cdr:cNvCxnSpPr>
          <a:stCxn xmlns:a="http://schemas.openxmlformats.org/drawingml/2006/main" id="7" idx="2"/>
        </cdr:cNvCxnSpPr>
      </cdr:nvCxnSpPr>
      <cdr:spPr>
        <a:xfrm xmlns:a="http://schemas.openxmlformats.org/drawingml/2006/main" flipH="1">
          <a:off x="5619750" y="995362"/>
          <a:ext cx="25488" cy="123826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4345</cdr:x>
      <cdr:y>0.23107</cdr:y>
    </cdr:from>
    <cdr:to>
      <cdr:x>0.67534</cdr:x>
      <cdr:y>0.27869</cdr:y>
    </cdr:to>
    <cdr:sp macro="" textlink="">
      <cdr:nvSpPr>
        <cdr:cNvPr id="13" name="TextovéPole 1">
          <a:extLst xmlns:a="http://schemas.openxmlformats.org/drawingml/2006/main">
            <a:ext uri="{FF2B5EF4-FFF2-40B4-BE49-F238E27FC236}">
              <a16:creationId xmlns:a16="http://schemas.microsoft.com/office/drawing/2014/main" id="{72855EFF-9677-4411-BADE-43A1973DB35B}"/>
            </a:ext>
          </a:extLst>
        </cdr:cNvPr>
        <cdr:cNvSpPr txBox="1"/>
      </cdr:nvSpPr>
      <cdr:spPr>
        <a:xfrm xmlns:a="http://schemas.openxmlformats.org/drawingml/2006/main">
          <a:off x="3260725" y="831850"/>
          <a:ext cx="791325" cy="171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 dirty="0">
              <a:latin typeface="Arial" panose="020B0604020202020204" pitchFamily="34" charset="0"/>
              <a:cs typeface="Arial" panose="020B0604020202020204" pitchFamily="34" charset="0"/>
            </a:rPr>
            <a:t>GDF-15</a:t>
          </a:r>
        </a:p>
      </cdr:txBody>
    </cdr:sp>
  </cdr:relSizeAnchor>
  <cdr:relSizeAnchor xmlns:cdr="http://schemas.openxmlformats.org/drawingml/2006/chartDrawing">
    <cdr:from>
      <cdr:x>0.59438</cdr:x>
      <cdr:y>0.27869</cdr:y>
    </cdr:from>
    <cdr:to>
      <cdr:x>0.6094</cdr:x>
      <cdr:y>0.32897</cdr:y>
    </cdr:to>
    <cdr:cxnSp macro="">
      <cdr:nvCxnSpPr>
        <cdr:cNvPr id="14" name="Přímá spojnice 13">
          <a:extLst xmlns:a="http://schemas.openxmlformats.org/drawingml/2006/main">
            <a:ext uri="{FF2B5EF4-FFF2-40B4-BE49-F238E27FC236}">
              <a16:creationId xmlns:a16="http://schemas.microsoft.com/office/drawing/2014/main" id="{23F4994A-4A3F-4F1F-BA69-A353D610FB5B}"/>
            </a:ext>
          </a:extLst>
        </cdr:cNvPr>
        <cdr:cNvCxnSpPr>
          <a:stCxn xmlns:a="http://schemas.openxmlformats.org/drawingml/2006/main" id="13" idx="2"/>
        </cdr:cNvCxnSpPr>
      </cdr:nvCxnSpPr>
      <cdr:spPr>
        <a:xfrm xmlns:a="http://schemas.openxmlformats.org/drawingml/2006/main" flipH="1">
          <a:off x="3566275" y="1003300"/>
          <a:ext cx="90113" cy="180974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3394</cdr:x>
      <cdr:y>0.26547</cdr:y>
    </cdr:from>
    <cdr:to>
      <cdr:x>0.76583</cdr:x>
      <cdr:y>0.31309</cdr:y>
    </cdr:to>
    <cdr:sp macro="" textlink="">
      <cdr:nvSpPr>
        <cdr:cNvPr id="15" name="TextovéPole 1">
          <a:extLst xmlns:a="http://schemas.openxmlformats.org/drawingml/2006/main">
            <a:ext uri="{FF2B5EF4-FFF2-40B4-BE49-F238E27FC236}">
              <a16:creationId xmlns:a16="http://schemas.microsoft.com/office/drawing/2014/main" id="{72855EFF-9677-4411-BADE-43A1973DB35B}"/>
            </a:ext>
          </a:extLst>
        </cdr:cNvPr>
        <cdr:cNvSpPr txBox="1"/>
      </cdr:nvSpPr>
      <cdr:spPr>
        <a:xfrm xmlns:a="http://schemas.openxmlformats.org/drawingml/2006/main">
          <a:off x="3803650" y="955675"/>
          <a:ext cx="791325" cy="171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>
              <a:latin typeface="Arial" panose="020B0604020202020204" pitchFamily="34" charset="0"/>
              <a:cs typeface="Arial" panose="020B0604020202020204" pitchFamily="34" charset="0"/>
            </a:rPr>
            <a:t>FGF-23</a:t>
          </a:r>
        </a:p>
      </cdr:txBody>
    </cdr:sp>
  </cdr:relSizeAnchor>
  <cdr:relSizeAnchor xmlns:cdr="http://schemas.openxmlformats.org/drawingml/2006/chartDrawing">
    <cdr:from>
      <cdr:x>0.65564</cdr:x>
      <cdr:y>0.31309</cdr:y>
    </cdr:from>
    <cdr:to>
      <cdr:x>0.69989</cdr:x>
      <cdr:y>0.34528</cdr:y>
    </cdr:to>
    <cdr:cxnSp macro="">
      <cdr:nvCxnSpPr>
        <cdr:cNvPr id="16" name="Přímá spojnice 15">
          <a:extLst xmlns:a="http://schemas.openxmlformats.org/drawingml/2006/main">
            <a:ext uri="{FF2B5EF4-FFF2-40B4-BE49-F238E27FC236}">
              <a16:creationId xmlns:a16="http://schemas.microsoft.com/office/drawing/2014/main" id="{23F4994A-4A3F-4F1F-BA69-A353D610FB5B}"/>
            </a:ext>
          </a:extLst>
        </cdr:cNvPr>
        <cdr:cNvCxnSpPr>
          <a:stCxn xmlns:a="http://schemas.openxmlformats.org/drawingml/2006/main" id="15" idx="2"/>
        </cdr:cNvCxnSpPr>
      </cdr:nvCxnSpPr>
      <cdr:spPr>
        <a:xfrm xmlns:a="http://schemas.openxmlformats.org/drawingml/2006/main" flipH="1">
          <a:off x="3933825" y="1127125"/>
          <a:ext cx="265488" cy="115888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985</cdr:x>
      <cdr:y>0.31309</cdr:y>
    </cdr:from>
    <cdr:to>
      <cdr:x>0.69989</cdr:x>
      <cdr:y>0.3638</cdr:y>
    </cdr:to>
    <cdr:cxnSp macro="">
      <cdr:nvCxnSpPr>
        <cdr:cNvPr id="19" name="Přímá spojnice 18">
          <a:extLst xmlns:a="http://schemas.openxmlformats.org/drawingml/2006/main">
            <a:ext uri="{FF2B5EF4-FFF2-40B4-BE49-F238E27FC236}">
              <a16:creationId xmlns:a16="http://schemas.microsoft.com/office/drawing/2014/main" id="{75A28485-1FDB-4402-9B20-1027820C864A}"/>
            </a:ext>
          </a:extLst>
        </cdr:cNvPr>
        <cdr:cNvCxnSpPr>
          <a:stCxn xmlns:a="http://schemas.openxmlformats.org/drawingml/2006/main" id="15" idx="2"/>
        </cdr:cNvCxnSpPr>
      </cdr:nvCxnSpPr>
      <cdr:spPr>
        <a:xfrm xmlns:a="http://schemas.openxmlformats.org/drawingml/2006/main" flipH="1">
          <a:off x="4191000" y="1127125"/>
          <a:ext cx="8313" cy="182563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043</cdr:x>
      <cdr:y>0.31309</cdr:y>
    </cdr:from>
    <cdr:to>
      <cdr:x>0.60232</cdr:x>
      <cdr:y>0.36072</cdr:y>
    </cdr:to>
    <cdr:sp macro="" textlink="">
      <cdr:nvSpPr>
        <cdr:cNvPr id="21" name="TextovéPole 1">
          <a:extLst xmlns:a="http://schemas.openxmlformats.org/drawingml/2006/main">
            <a:ext uri="{FF2B5EF4-FFF2-40B4-BE49-F238E27FC236}">
              <a16:creationId xmlns:a16="http://schemas.microsoft.com/office/drawing/2014/main" id="{3AEF8B90-6F7D-47FD-8451-5C9F4E4C3B28}"/>
            </a:ext>
          </a:extLst>
        </cdr:cNvPr>
        <cdr:cNvSpPr txBox="1"/>
      </cdr:nvSpPr>
      <cdr:spPr>
        <a:xfrm xmlns:a="http://schemas.openxmlformats.org/drawingml/2006/main">
          <a:off x="2822575" y="1127125"/>
          <a:ext cx="791325" cy="171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>
              <a:latin typeface="Arial" panose="020B0604020202020204" pitchFamily="34" charset="0"/>
              <a:cs typeface="Arial" panose="020B0604020202020204" pitchFamily="34" charset="0"/>
            </a:rPr>
            <a:t>IL8</a:t>
          </a:r>
        </a:p>
      </cdr:txBody>
    </cdr:sp>
  </cdr:relSizeAnchor>
  <cdr:relSizeAnchor xmlns:cdr="http://schemas.openxmlformats.org/drawingml/2006/chartDrawing">
    <cdr:from>
      <cdr:x>0.54568</cdr:x>
      <cdr:y>0.36977</cdr:y>
    </cdr:from>
    <cdr:to>
      <cdr:x>0.55065</cdr:x>
      <cdr:y>0.41254</cdr:y>
    </cdr:to>
    <cdr:cxnSp macro="">
      <cdr:nvCxnSpPr>
        <cdr:cNvPr id="22" name="Přímá spojnice 21">
          <a:extLst xmlns:a="http://schemas.openxmlformats.org/drawingml/2006/main">
            <a:ext uri="{FF2B5EF4-FFF2-40B4-BE49-F238E27FC236}">
              <a16:creationId xmlns:a16="http://schemas.microsoft.com/office/drawing/2014/main" id="{C2A32D06-E2F9-4428-BFC3-16EF2CBBCC8E}"/>
            </a:ext>
          </a:extLst>
        </cdr:cNvPr>
        <cdr:cNvCxnSpPr/>
      </cdr:nvCxnSpPr>
      <cdr:spPr>
        <a:xfrm xmlns:a="http://schemas.openxmlformats.org/drawingml/2006/main">
          <a:off x="2290148" y="1595856"/>
          <a:ext cx="20858" cy="184585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0909</cdr:x>
      <cdr:y>0.40643</cdr:y>
    </cdr:from>
    <cdr:to>
      <cdr:x>0.69429</cdr:x>
      <cdr:y>0.45626</cdr:y>
    </cdr:to>
    <cdr:sp macro="" textlink="">
      <cdr:nvSpPr>
        <cdr:cNvPr id="24" name="TextovéPole 1">
          <a:extLst xmlns:a="http://schemas.openxmlformats.org/drawingml/2006/main">
            <a:ext uri="{FF2B5EF4-FFF2-40B4-BE49-F238E27FC236}">
              <a16:creationId xmlns:a16="http://schemas.microsoft.com/office/drawing/2014/main" id="{A9BEF832-9999-412E-9AE4-F235F829221C}"/>
            </a:ext>
          </a:extLst>
        </cdr:cNvPr>
        <cdr:cNvSpPr txBox="1"/>
      </cdr:nvSpPr>
      <cdr:spPr>
        <a:xfrm xmlns:a="http://schemas.openxmlformats.org/drawingml/2006/main">
          <a:off x="2630268" y="1808072"/>
          <a:ext cx="367927" cy="2216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 dirty="0">
              <a:latin typeface="Arial" panose="020B0604020202020204" pitchFamily="34" charset="0"/>
              <a:cs typeface="Arial" panose="020B0604020202020204" pitchFamily="34" charset="0"/>
            </a:rPr>
            <a:t>ACE2</a:t>
          </a:r>
        </a:p>
      </cdr:txBody>
    </cdr:sp>
  </cdr:relSizeAnchor>
  <cdr:relSizeAnchor xmlns:cdr="http://schemas.openxmlformats.org/drawingml/2006/chartDrawing">
    <cdr:from>
      <cdr:x>0.55408</cdr:x>
      <cdr:y>0.45213</cdr:y>
    </cdr:from>
    <cdr:to>
      <cdr:x>0.59218</cdr:x>
      <cdr:y>0.46272</cdr:y>
    </cdr:to>
    <cdr:cxnSp macro="">
      <cdr:nvCxnSpPr>
        <cdr:cNvPr id="25" name="Přímá spojnice 24">
          <a:extLst xmlns:a="http://schemas.openxmlformats.org/drawingml/2006/main">
            <a:ext uri="{FF2B5EF4-FFF2-40B4-BE49-F238E27FC236}">
              <a16:creationId xmlns:a16="http://schemas.microsoft.com/office/drawing/2014/main" id="{F95C9EDE-2A55-4484-AC30-8586254A4FDA}"/>
            </a:ext>
          </a:extLst>
        </cdr:cNvPr>
        <cdr:cNvCxnSpPr/>
      </cdr:nvCxnSpPr>
      <cdr:spPr>
        <a:xfrm xmlns:a="http://schemas.openxmlformats.org/drawingml/2006/main" flipH="1">
          <a:off x="2325393" y="1951287"/>
          <a:ext cx="159900" cy="45704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9262</cdr:x>
      <cdr:y>0.47713</cdr:y>
    </cdr:from>
    <cdr:to>
      <cdr:x>0.3245</cdr:x>
      <cdr:y>0.52476</cdr:y>
    </cdr:to>
    <cdr:sp macro="" textlink="">
      <cdr:nvSpPr>
        <cdr:cNvPr id="32" name="TextovéPole 1">
          <a:extLst xmlns:a="http://schemas.openxmlformats.org/drawingml/2006/main">
            <a:ext uri="{FF2B5EF4-FFF2-40B4-BE49-F238E27FC236}">
              <a16:creationId xmlns:a16="http://schemas.microsoft.com/office/drawing/2014/main" id="{989984EF-6CED-4A39-B74D-B3996AA6359B}"/>
            </a:ext>
          </a:extLst>
        </cdr:cNvPr>
        <cdr:cNvSpPr txBox="1"/>
      </cdr:nvSpPr>
      <cdr:spPr>
        <a:xfrm xmlns:a="http://schemas.openxmlformats.org/drawingml/2006/main">
          <a:off x="1155700" y="1717675"/>
          <a:ext cx="791325" cy="171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 dirty="0">
              <a:latin typeface="Arial" panose="020B0604020202020204" pitchFamily="34" charset="0"/>
              <a:cs typeface="Arial" panose="020B0604020202020204" pitchFamily="34" charset="0"/>
            </a:rPr>
            <a:t>PON3</a:t>
          </a:r>
        </a:p>
      </cdr:txBody>
    </cdr:sp>
  </cdr:relSizeAnchor>
  <cdr:relSizeAnchor xmlns:cdr="http://schemas.openxmlformats.org/drawingml/2006/chartDrawing">
    <cdr:from>
      <cdr:x>0.27718</cdr:x>
      <cdr:y>0.53925</cdr:y>
    </cdr:from>
    <cdr:to>
      <cdr:x>0.29485</cdr:x>
      <cdr:y>0.57938</cdr:y>
    </cdr:to>
    <cdr:cxnSp macro="">
      <cdr:nvCxnSpPr>
        <cdr:cNvPr id="33" name="Přímá spojnice 32">
          <a:extLst xmlns:a="http://schemas.openxmlformats.org/drawingml/2006/main">
            <a:ext uri="{FF2B5EF4-FFF2-40B4-BE49-F238E27FC236}">
              <a16:creationId xmlns:a16="http://schemas.microsoft.com/office/drawing/2014/main" id="{26330D7D-6BC4-45A1-9D7D-C5ED60D80CA4}"/>
            </a:ext>
          </a:extLst>
        </cdr:cNvPr>
        <cdr:cNvCxnSpPr/>
      </cdr:nvCxnSpPr>
      <cdr:spPr>
        <a:xfrm xmlns:a="http://schemas.openxmlformats.org/drawingml/2006/main">
          <a:off x="1163295" y="2327258"/>
          <a:ext cx="74158" cy="173191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4499</cdr:x>
      <cdr:y>0.63758</cdr:y>
    </cdr:from>
    <cdr:to>
      <cdr:x>0.27688</cdr:x>
      <cdr:y>0.6852</cdr:y>
    </cdr:to>
    <cdr:sp macro="" textlink="">
      <cdr:nvSpPr>
        <cdr:cNvPr id="35" name="TextovéPole 1">
          <a:extLst xmlns:a="http://schemas.openxmlformats.org/drawingml/2006/main">
            <a:ext uri="{FF2B5EF4-FFF2-40B4-BE49-F238E27FC236}">
              <a16:creationId xmlns:a16="http://schemas.microsoft.com/office/drawing/2014/main" id="{3C11DC89-3C6B-4835-930E-C07570F8218A}"/>
            </a:ext>
          </a:extLst>
        </cdr:cNvPr>
        <cdr:cNvSpPr txBox="1"/>
      </cdr:nvSpPr>
      <cdr:spPr>
        <a:xfrm xmlns:a="http://schemas.openxmlformats.org/drawingml/2006/main">
          <a:off x="626105" y="2836340"/>
          <a:ext cx="569553" cy="21184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cs-CZ" sz="900" b="1" dirty="0">
              <a:latin typeface="Arial" panose="020B0604020202020204" pitchFamily="34" charset="0"/>
              <a:cs typeface="Arial" panose="020B0604020202020204" pitchFamily="34" charset="0"/>
            </a:rPr>
            <a:t>TWEAK</a:t>
          </a:r>
        </a:p>
      </cdr:txBody>
    </cdr:sp>
  </cdr:relSizeAnchor>
  <cdr:relSizeAnchor xmlns:cdr="http://schemas.openxmlformats.org/drawingml/2006/chartDrawing">
    <cdr:from>
      <cdr:x>0.19327</cdr:x>
      <cdr:y>0.69223</cdr:y>
    </cdr:from>
    <cdr:to>
      <cdr:x>0.21093</cdr:x>
      <cdr:y>0.73236</cdr:y>
    </cdr:to>
    <cdr:cxnSp macro="">
      <cdr:nvCxnSpPr>
        <cdr:cNvPr id="36" name="Přímá spojnice 35">
          <a:extLst xmlns:a="http://schemas.openxmlformats.org/drawingml/2006/main">
            <a:ext uri="{FF2B5EF4-FFF2-40B4-BE49-F238E27FC236}">
              <a16:creationId xmlns:a16="http://schemas.microsoft.com/office/drawing/2014/main" id="{CC72D8B2-F4E0-4AA1-8237-9ADB7F645E30}"/>
            </a:ext>
          </a:extLst>
        </cdr:cNvPr>
        <cdr:cNvCxnSpPr/>
      </cdr:nvCxnSpPr>
      <cdr:spPr>
        <a:xfrm xmlns:a="http://schemas.openxmlformats.org/drawingml/2006/main">
          <a:off x="834619" y="3079444"/>
          <a:ext cx="76263" cy="178523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5614</cdr:x>
      <cdr:y>0.04941</cdr:y>
    </cdr:from>
    <cdr:to>
      <cdr:x>0.26572</cdr:x>
      <cdr:y>0.1247</cdr:y>
    </cdr:to>
    <cdr:sp macro="" textlink="">
      <cdr:nvSpPr>
        <cdr:cNvPr id="23" name="TextovéPole 1">
          <a:extLst xmlns:a="http://schemas.openxmlformats.org/drawingml/2006/main">
            <a:ext uri="{FF2B5EF4-FFF2-40B4-BE49-F238E27FC236}">
              <a16:creationId xmlns:a16="http://schemas.microsoft.com/office/drawing/2014/main" id="{2A51E29C-3050-4ACF-AB1B-13727867FF35}"/>
            </a:ext>
          </a:extLst>
        </cdr:cNvPr>
        <cdr:cNvSpPr txBox="1"/>
      </cdr:nvSpPr>
      <cdr:spPr>
        <a:xfrm xmlns:a="http://schemas.openxmlformats.org/drawingml/2006/main">
          <a:off x="674277" y="219819"/>
          <a:ext cx="473209" cy="3349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cs-CZ" sz="1000" b="0" i="0" u="none" strike="noStrike" baseline="0" dirty="0" err="1">
              <a:latin typeface="Arial" panose="020B0604020202020204" pitchFamily="34" charset="0"/>
              <a:ea typeface="+mn-ea"/>
              <a:cs typeface="Arial" panose="020B0604020202020204" pitchFamily="34" charset="0"/>
            </a:rPr>
            <a:t>down</a:t>
          </a:r>
          <a:r>
            <a:rPr lang="cs-CZ" sz="1000" b="0" i="0" u="none" strike="noStrike" baseline="0" dirty="0">
              <a:latin typeface="Arial" panose="020B0604020202020204" pitchFamily="34" charset="0"/>
              <a:ea typeface="+mn-ea"/>
              <a:cs typeface="Arial" panose="020B0604020202020204" pitchFamily="34" charset="0"/>
            </a:rPr>
            <a:t> (5)</a:t>
          </a:r>
          <a:endParaRPr lang="cs-CZ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018</cdr:x>
      <cdr:y>0.04851</cdr:y>
    </cdr:from>
    <cdr:to>
      <cdr:x>0.60004</cdr:x>
      <cdr:y>0.12379</cdr:y>
    </cdr:to>
    <cdr:sp macro="" textlink="">
      <cdr:nvSpPr>
        <cdr:cNvPr id="26" name="TextovéPole 1">
          <a:extLst xmlns:a="http://schemas.openxmlformats.org/drawingml/2006/main">
            <a:ext uri="{FF2B5EF4-FFF2-40B4-BE49-F238E27FC236}">
              <a16:creationId xmlns:a16="http://schemas.microsoft.com/office/drawing/2014/main" id="{55FE986D-B81F-4DE1-BD55-D3B35E09D4BB}"/>
            </a:ext>
          </a:extLst>
        </cdr:cNvPr>
        <cdr:cNvSpPr txBox="1"/>
      </cdr:nvSpPr>
      <cdr:spPr>
        <a:xfrm xmlns:a="http://schemas.openxmlformats.org/drawingml/2006/main">
          <a:off x="2203140" y="215802"/>
          <a:ext cx="388051" cy="3348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cs-CZ" sz="1000" b="0" i="0" u="none" strike="noStrike" baseline="0" dirty="0">
              <a:latin typeface="Arial" panose="020B0604020202020204" pitchFamily="34" charset="0"/>
              <a:ea typeface="+mn-ea"/>
              <a:cs typeface="Arial" panose="020B0604020202020204" pitchFamily="34" charset="0"/>
            </a:rPr>
            <a:t>up (33)</a:t>
          </a:r>
          <a:endParaRPr lang="cs-CZ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2975</cdr:x>
      <cdr:y>0.03626</cdr:y>
    </cdr:from>
    <cdr:to>
      <cdr:x>0.60501</cdr:x>
      <cdr:y>0.09554</cdr:y>
    </cdr:to>
    <cdr:sp macro="" textlink="">
      <cdr:nvSpPr>
        <cdr:cNvPr id="4" name="TextovéPole 1">
          <a:extLst xmlns:a="http://schemas.openxmlformats.org/drawingml/2006/main">
            <a:ext uri="{FF2B5EF4-FFF2-40B4-BE49-F238E27FC236}">
              <a16:creationId xmlns:a16="http://schemas.microsoft.com/office/drawing/2014/main" id="{42D654C6-8F75-4E76-A611-43674A7137F0}"/>
            </a:ext>
          </a:extLst>
        </cdr:cNvPr>
        <cdr:cNvSpPr txBox="1"/>
      </cdr:nvSpPr>
      <cdr:spPr>
        <a:xfrm xmlns:a="http://schemas.openxmlformats.org/drawingml/2006/main">
          <a:off x="2860676" y="117475"/>
          <a:ext cx="406400" cy="1920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cs-CZ" sz="900" b="1" i="0" u="none" strike="noStrike" baseline="0" dirty="0">
              <a:latin typeface="Arial" panose="020B0604020202020204" pitchFamily="34" charset="0"/>
              <a:ea typeface="+mn-ea"/>
              <a:cs typeface="Arial" panose="020B0604020202020204" pitchFamily="34" charset="0"/>
            </a:rPr>
            <a:t>CCL3</a:t>
          </a:r>
          <a:endParaRPr lang="cs-CZ" sz="9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6738</cdr:x>
      <cdr:y>0.09635</cdr:y>
    </cdr:from>
    <cdr:to>
      <cdr:x>0.58382</cdr:x>
      <cdr:y>0.14895</cdr:y>
    </cdr:to>
    <cdr:cxnSp macro="">
      <cdr:nvCxnSpPr>
        <cdr:cNvPr id="6" name="Přímá spojnice 5">
          <a:extLst xmlns:a="http://schemas.openxmlformats.org/drawingml/2006/main">
            <a:ext uri="{FF2B5EF4-FFF2-40B4-BE49-F238E27FC236}">
              <a16:creationId xmlns:a16="http://schemas.microsoft.com/office/drawing/2014/main" id="{5A77895E-D2C3-4AD9-9A1E-BE45B9CFEE0E}"/>
            </a:ext>
          </a:extLst>
        </cdr:cNvPr>
        <cdr:cNvCxnSpPr/>
      </cdr:nvCxnSpPr>
      <cdr:spPr>
        <a:xfrm xmlns:a="http://schemas.openxmlformats.org/drawingml/2006/main" flipH="1">
          <a:off x="2013169" y="412498"/>
          <a:ext cx="58317" cy="225188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084</cdr:x>
      <cdr:y>0.09554</cdr:y>
    </cdr:from>
    <cdr:to>
      <cdr:x>0.59202</cdr:x>
      <cdr:y>0.14846</cdr:y>
    </cdr:to>
    <cdr:cxnSp macro="">
      <cdr:nvCxnSpPr>
        <cdr:cNvPr id="9" name="Přímá spojnice 8">
          <a:extLst xmlns:a="http://schemas.openxmlformats.org/drawingml/2006/main">
            <a:ext uri="{FF2B5EF4-FFF2-40B4-BE49-F238E27FC236}">
              <a16:creationId xmlns:a16="http://schemas.microsoft.com/office/drawing/2014/main" id="{FB02477D-30DF-42D8-B53C-4C6CE5BE6978}"/>
            </a:ext>
          </a:extLst>
        </cdr:cNvPr>
        <cdr:cNvCxnSpPr/>
      </cdr:nvCxnSpPr>
      <cdr:spPr>
        <a:xfrm xmlns:a="http://schemas.openxmlformats.org/drawingml/2006/main">
          <a:off x="2060936" y="409023"/>
          <a:ext cx="39669" cy="226559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1053</cdr:x>
      <cdr:y>0.11734</cdr:y>
    </cdr:from>
    <cdr:to>
      <cdr:x>0.34635</cdr:x>
      <cdr:y>0.18201</cdr:y>
    </cdr:to>
    <cdr:sp macro="" textlink="">
      <cdr:nvSpPr>
        <cdr:cNvPr id="10" name="TextovéPole 9">
          <a:extLst xmlns:a="http://schemas.openxmlformats.org/drawingml/2006/main">
            <a:ext uri="{FF2B5EF4-FFF2-40B4-BE49-F238E27FC236}">
              <a16:creationId xmlns:a16="http://schemas.microsoft.com/office/drawing/2014/main" id="{52DA131C-EB97-4FC1-9A0F-65935082E6EE}"/>
            </a:ext>
          </a:extLst>
        </cdr:cNvPr>
        <cdr:cNvSpPr txBox="1"/>
      </cdr:nvSpPr>
      <cdr:spPr>
        <a:xfrm xmlns:a="http://schemas.openxmlformats.org/drawingml/2006/main">
          <a:off x="746990" y="502372"/>
          <a:ext cx="481915" cy="2768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cs-CZ" sz="900" b="1" dirty="0">
              <a:latin typeface="Arial" panose="020B0604020202020204" pitchFamily="34" charset="0"/>
              <a:cs typeface="Arial" panose="020B0604020202020204" pitchFamily="34" charset="0"/>
            </a:rPr>
            <a:t>TNFRSF13B</a:t>
          </a:r>
        </a:p>
      </cdr:txBody>
    </cdr:sp>
  </cdr:relSizeAnchor>
  <cdr:relSizeAnchor xmlns:cdr="http://schemas.openxmlformats.org/drawingml/2006/chartDrawing">
    <cdr:from>
      <cdr:x>0.44919</cdr:x>
      <cdr:y>0.15692</cdr:y>
    </cdr:from>
    <cdr:to>
      <cdr:x>0.50976</cdr:x>
      <cdr:y>0.18668</cdr:y>
    </cdr:to>
    <cdr:cxnSp macro="">
      <cdr:nvCxnSpPr>
        <cdr:cNvPr id="11" name="Přímá spojnice 10">
          <a:extLst xmlns:a="http://schemas.openxmlformats.org/drawingml/2006/main">
            <a:ext uri="{FF2B5EF4-FFF2-40B4-BE49-F238E27FC236}">
              <a16:creationId xmlns:a16="http://schemas.microsoft.com/office/drawing/2014/main" id="{08E411E7-D3BA-41E7-8E76-B859B631BA16}"/>
            </a:ext>
          </a:extLst>
        </cdr:cNvPr>
        <cdr:cNvCxnSpPr/>
      </cdr:nvCxnSpPr>
      <cdr:spPr>
        <a:xfrm xmlns:a="http://schemas.openxmlformats.org/drawingml/2006/main">
          <a:off x="1593815" y="671806"/>
          <a:ext cx="214908" cy="127402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1438</cdr:x>
      <cdr:y>0.07154</cdr:y>
    </cdr:from>
    <cdr:to>
      <cdr:x>0.79434</cdr:x>
      <cdr:y>0.13082</cdr:y>
    </cdr:to>
    <cdr:sp macro="" textlink="">
      <cdr:nvSpPr>
        <cdr:cNvPr id="13" name="TextovéPole 1">
          <a:extLst xmlns:a="http://schemas.openxmlformats.org/drawingml/2006/main">
            <a:ext uri="{FF2B5EF4-FFF2-40B4-BE49-F238E27FC236}">
              <a16:creationId xmlns:a16="http://schemas.microsoft.com/office/drawing/2014/main" id="{77BE90C8-0D0F-42D7-8837-11E3F6E9E809}"/>
            </a:ext>
          </a:extLst>
        </cdr:cNvPr>
        <cdr:cNvSpPr txBox="1"/>
      </cdr:nvSpPr>
      <cdr:spPr>
        <a:xfrm xmlns:a="http://schemas.openxmlformats.org/drawingml/2006/main">
          <a:off x="3857625" y="231775"/>
          <a:ext cx="431800" cy="1920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cs-CZ" sz="900" b="1" dirty="0">
              <a:latin typeface="Arial" panose="020B0604020202020204" pitchFamily="34" charset="0"/>
              <a:cs typeface="Arial" panose="020B0604020202020204" pitchFamily="34" charset="0"/>
            </a:rPr>
            <a:t>PSP-D</a:t>
          </a:r>
        </a:p>
      </cdr:txBody>
    </cdr:sp>
  </cdr:relSizeAnchor>
  <cdr:relSizeAnchor xmlns:cdr="http://schemas.openxmlformats.org/drawingml/2006/chartDrawing">
    <cdr:from>
      <cdr:x>0.71438</cdr:x>
      <cdr:y>0.13082</cdr:y>
    </cdr:from>
    <cdr:to>
      <cdr:x>0.75436</cdr:x>
      <cdr:y>0.1514</cdr:y>
    </cdr:to>
    <cdr:cxnSp macro="">
      <cdr:nvCxnSpPr>
        <cdr:cNvPr id="14" name="Přímá spojnice 13">
          <a:extLst xmlns:a="http://schemas.openxmlformats.org/drawingml/2006/main">
            <a:ext uri="{FF2B5EF4-FFF2-40B4-BE49-F238E27FC236}">
              <a16:creationId xmlns:a16="http://schemas.microsoft.com/office/drawing/2014/main" id="{F51B504B-D1DA-4EA3-ABB5-CC16F2E25A7C}"/>
            </a:ext>
          </a:extLst>
        </cdr:cNvPr>
        <cdr:cNvCxnSpPr>
          <a:stCxn xmlns:a="http://schemas.openxmlformats.org/drawingml/2006/main" id="13" idx="2"/>
        </cdr:cNvCxnSpPr>
      </cdr:nvCxnSpPr>
      <cdr:spPr>
        <a:xfrm xmlns:a="http://schemas.openxmlformats.org/drawingml/2006/main" flipH="1">
          <a:off x="3857626" y="423863"/>
          <a:ext cx="215899" cy="66675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6B4C89-0AB0-45C3-817B-595C35013109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FDBA06-650B-4A23-84EA-30DEB8031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434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FDBA06-650B-4A23-84EA-30DEB803191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381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868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031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176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841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582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826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667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110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86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30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97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67B5A-902C-47CB-B569-7A6561AC3BDC}" type="datetimeFigureOut">
              <a:rPr lang="en-US" smtClean="0"/>
              <a:t>1/28/2025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B9BF1-622B-439F-888F-6849954085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31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ovéPole 5"/>
          <p:cNvSpPr txBox="1"/>
          <p:nvPr/>
        </p:nvSpPr>
        <p:spPr>
          <a:xfrm>
            <a:off x="3771849" y="549712"/>
            <a:ext cx="3600666" cy="307777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~900 RHC within 6/2017-6/2020 at IKEM</a:t>
            </a:r>
          </a:p>
        </p:txBody>
      </p:sp>
      <p:sp>
        <p:nvSpPr>
          <p:cNvPr id="7" name="TextovéPole 6"/>
          <p:cNvSpPr txBox="1"/>
          <p:nvPr/>
        </p:nvSpPr>
        <p:spPr>
          <a:xfrm>
            <a:off x="6270892" y="1695450"/>
            <a:ext cx="4164923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13 HFrEF patients fulfilling the criteria, signed IC,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 sampling attempted               </a:t>
            </a:r>
          </a:p>
        </p:txBody>
      </p:sp>
      <p:sp>
        <p:nvSpPr>
          <p:cNvPr id="8" name="TextovéPole 7"/>
          <p:cNvSpPr txBox="1"/>
          <p:nvPr/>
        </p:nvSpPr>
        <p:spPr>
          <a:xfrm>
            <a:off x="6270892" y="2711113"/>
            <a:ext cx="4164923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60 HFrEF patients with complete hemodynamic data and PA samples with adequate quality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PA wedge saturation&gt;85%)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VR median 2.88 (IQR 1.90-3.92)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w.u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9" name="TextovéPole 8"/>
          <p:cNvSpPr txBox="1"/>
          <p:nvPr/>
        </p:nvSpPr>
        <p:spPr>
          <a:xfrm>
            <a:off x="4646017" y="4425493"/>
            <a:ext cx="2880917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HFrEF patients with low PVR</a:t>
            </a:r>
          </a:p>
          <a:p>
            <a:pPr algn="ctr"/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Q1 of PVR distribution)</a:t>
            </a:r>
          </a:p>
        </p:txBody>
      </p:sp>
      <p:sp>
        <p:nvSpPr>
          <p:cNvPr id="10" name="TextovéPole 9"/>
          <p:cNvSpPr txBox="1"/>
          <p:nvPr/>
        </p:nvSpPr>
        <p:spPr>
          <a:xfrm>
            <a:off x="8543276" y="4408704"/>
            <a:ext cx="295946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HFrEF patients with high PVR</a:t>
            </a:r>
          </a:p>
          <a:p>
            <a:pPr algn="ctr"/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Q4 of PVR distribution)</a:t>
            </a:r>
          </a:p>
        </p:txBody>
      </p:sp>
      <p:sp>
        <p:nvSpPr>
          <p:cNvPr id="11" name="TextovéPole 10"/>
          <p:cNvSpPr txBox="1"/>
          <p:nvPr/>
        </p:nvSpPr>
        <p:spPr>
          <a:xfrm>
            <a:off x="514351" y="1695450"/>
            <a:ext cx="4457700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1 non-HF subjects who underwent RHC to rule out  cardiac disease (n=5) or non-HF subjects who underwent RHC during other medically indicated procedure (PFO closure, n=16), had normal echocardiography and hemodynamics, signed IC, and underwent PA sampling (adequate quality in all)</a:t>
            </a:r>
          </a:p>
        </p:txBody>
      </p:sp>
      <p:sp>
        <p:nvSpPr>
          <p:cNvPr id="12" name="TextovéPole 11"/>
          <p:cNvSpPr txBox="1"/>
          <p:nvPr/>
        </p:nvSpPr>
        <p:spPr>
          <a:xfrm>
            <a:off x="1802276" y="4425493"/>
            <a:ext cx="1762856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1 controls </a:t>
            </a:r>
          </a:p>
        </p:txBody>
      </p:sp>
      <p:sp>
        <p:nvSpPr>
          <p:cNvPr id="13" name="TextovéPole 12"/>
          <p:cNvSpPr txBox="1"/>
          <p:nvPr/>
        </p:nvSpPr>
        <p:spPr>
          <a:xfrm>
            <a:off x="8686800" y="5858886"/>
            <a:ext cx="2359941" cy="9002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HC: right heart catheterization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VR: pulmonary vascular resistance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FO: patent foramen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ovale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A: pulmonary artery</a:t>
            </a:r>
            <a:endParaRPr lang="cs-CZ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cs-CZ" sz="1050" dirty="0" err="1">
                <a:latin typeface="Arial" panose="020B0604020202020204" pitchFamily="34" charset="0"/>
                <a:cs typeface="Arial" panose="020B0604020202020204" pitchFamily="34" charset="0"/>
              </a:rPr>
              <a:t>w.u</a:t>
            </a:r>
            <a:r>
              <a:rPr lang="cs-CZ" sz="1050" dirty="0">
                <a:latin typeface="Arial" panose="020B0604020202020204" pitchFamily="34" charset="0"/>
                <a:cs typeface="Arial" panose="020B0604020202020204" pitchFamily="34" charset="0"/>
              </a:rPr>
              <a:t>.: </a:t>
            </a:r>
            <a:r>
              <a:rPr lang="cs-CZ" sz="1050" dirty="0" err="1">
                <a:latin typeface="Arial" panose="020B0604020202020204" pitchFamily="34" charset="0"/>
                <a:cs typeface="Arial" panose="020B0604020202020204" pitchFamily="34" charset="0"/>
              </a:rPr>
              <a:t>Wood</a:t>
            </a:r>
            <a:r>
              <a:rPr lang="cs-CZ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050" dirty="0" err="1"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Přímá spojnice se šipkou 14"/>
          <p:cNvCxnSpPr>
            <a:stCxn id="6" idx="2"/>
            <a:endCxn id="11" idx="0"/>
          </p:cNvCxnSpPr>
          <p:nvPr/>
        </p:nvCxnSpPr>
        <p:spPr>
          <a:xfrm flipH="1">
            <a:off x="2743201" y="857489"/>
            <a:ext cx="2828981" cy="8379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Přímá spojnice se šipkou 15"/>
          <p:cNvCxnSpPr>
            <a:stCxn id="6" idx="2"/>
            <a:endCxn id="7" idx="0"/>
          </p:cNvCxnSpPr>
          <p:nvPr/>
        </p:nvCxnSpPr>
        <p:spPr>
          <a:xfrm>
            <a:off x="5572182" y="857489"/>
            <a:ext cx="2781172" cy="8379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Přímá spojnice se šipkou 18"/>
          <p:cNvCxnSpPr/>
          <p:nvPr/>
        </p:nvCxnSpPr>
        <p:spPr>
          <a:xfrm flipH="1">
            <a:off x="2743201" y="3080445"/>
            <a:ext cx="6529" cy="133189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Přímá spojnice se šipkou 20"/>
          <p:cNvCxnSpPr>
            <a:stCxn id="8" idx="2"/>
            <a:endCxn id="9" idx="0"/>
          </p:cNvCxnSpPr>
          <p:nvPr/>
        </p:nvCxnSpPr>
        <p:spPr>
          <a:xfrm flipH="1">
            <a:off x="6086476" y="3665220"/>
            <a:ext cx="2266878" cy="7602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Přímá spojnice se šipkou 22"/>
          <p:cNvCxnSpPr>
            <a:stCxn id="8" idx="2"/>
            <a:endCxn id="10" idx="0"/>
          </p:cNvCxnSpPr>
          <p:nvPr/>
        </p:nvCxnSpPr>
        <p:spPr>
          <a:xfrm>
            <a:off x="8353354" y="3665220"/>
            <a:ext cx="1669655" cy="7434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Přímá spojnice se šipkou 26"/>
          <p:cNvCxnSpPr>
            <a:stCxn id="7" idx="2"/>
            <a:endCxn id="8" idx="0"/>
          </p:cNvCxnSpPr>
          <p:nvPr/>
        </p:nvCxnSpPr>
        <p:spPr>
          <a:xfrm>
            <a:off x="8353354" y="2218670"/>
            <a:ext cx="0" cy="49244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ovéPole 1">
            <a:extLst>
              <a:ext uri="{FF2B5EF4-FFF2-40B4-BE49-F238E27FC236}">
                <a16:creationId xmlns:a16="http://schemas.microsoft.com/office/drawing/2014/main" id="{246C4AF2-236B-4A27-A979-7F3D0A8F8852}"/>
              </a:ext>
            </a:extLst>
          </p:cNvPr>
          <p:cNvSpPr txBox="1"/>
          <p:nvPr/>
        </p:nvSpPr>
        <p:spPr>
          <a:xfrm>
            <a:off x="287705" y="18038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ovéPole 16"/>
          <p:cNvSpPr txBox="1"/>
          <p:nvPr/>
        </p:nvSpPr>
        <p:spPr>
          <a:xfrm>
            <a:off x="287705" y="6241374"/>
            <a:ext cx="6675097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: CONSORT diagram and patients disposition in the study</a:t>
            </a:r>
          </a:p>
        </p:txBody>
      </p:sp>
    </p:spTree>
    <p:extLst>
      <p:ext uri="{BB962C8B-B14F-4D97-AF65-F5344CB8AC3E}">
        <p14:creationId xmlns:p14="http://schemas.microsoft.com/office/powerpoint/2010/main" val="3341685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ázek 2">
            <a:extLst>
              <a:ext uri="{FF2B5EF4-FFF2-40B4-BE49-F238E27FC236}">
                <a16:creationId xmlns:a16="http://schemas.microsoft.com/office/drawing/2014/main" id="{F63B41F3-898B-4C3A-8A72-1F07F6DDCBC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291" y="0"/>
            <a:ext cx="6667668" cy="6858000"/>
          </a:xfrm>
          <a:prstGeom prst="rect">
            <a:avLst/>
          </a:prstGeom>
        </p:spPr>
      </p:pic>
      <p:sp>
        <p:nvSpPr>
          <p:cNvPr id="5" name="TextovéPole 4">
            <a:extLst>
              <a:ext uri="{FF2B5EF4-FFF2-40B4-BE49-F238E27FC236}">
                <a16:creationId xmlns:a16="http://schemas.microsoft.com/office/drawing/2014/main" id="{F07AC3D5-E1C9-421F-956C-847A8336F369}"/>
              </a:ext>
            </a:extLst>
          </p:cNvPr>
          <p:cNvSpPr txBox="1"/>
          <p:nvPr/>
        </p:nvSpPr>
        <p:spPr>
          <a:xfrm>
            <a:off x="287705" y="18038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ovéPole 3">
            <a:extLst>
              <a:ext uri="{FF2B5EF4-FFF2-40B4-BE49-F238E27FC236}">
                <a16:creationId xmlns:a16="http://schemas.microsoft.com/office/drawing/2014/main" id="{B81E0CE0-DD57-4A94-8DE2-275EF213F6B3}"/>
              </a:ext>
            </a:extLst>
          </p:cNvPr>
          <p:cNvSpPr txBox="1"/>
          <p:nvPr/>
        </p:nvSpPr>
        <p:spPr>
          <a:xfrm>
            <a:off x="353693" y="4164978"/>
            <a:ext cx="4385895" cy="21236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2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Histogram showing distribution of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ulmonary vascular resist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c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PVR) in Wood´s units and cutoffs for top and bottom quartiles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) The correlation between BNP (ln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 measured by immunoassay from peripheral vein and by PEA from mixed venous blood from PA artery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) The correlation between Interleukin 6 measured by PEA and by IL-6 by ELISA (both from mixed venous blood from PA artery)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) The correlation between IL-6 measured by different PEA Olink panels (CVII or Inflammation).   </a:t>
            </a:r>
          </a:p>
        </p:txBody>
      </p:sp>
    </p:spTree>
    <p:extLst>
      <p:ext uri="{BB962C8B-B14F-4D97-AF65-F5344CB8AC3E}">
        <p14:creationId xmlns:p14="http://schemas.microsoft.com/office/powerpoint/2010/main" val="12876833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Graf 6">
            <a:extLst>
              <a:ext uri="{FF2B5EF4-FFF2-40B4-BE49-F238E27FC236}">
                <a16:creationId xmlns:a16="http://schemas.microsoft.com/office/drawing/2014/main" id="{531EB098-1E46-4740-B6D6-0EBFDB26883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94640353"/>
              </p:ext>
            </p:extLst>
          </p:nvPr>
        </p:nvGraphicFramePr>
        <p:xfrm>
          <a:off x="3438770" y="653618"/>
          <a:ext cx="4196862" cy="43157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ovéPole 1">
            <a:extLst>
              <a:ext uri="{FF2B5EF4-FFF2-40B4-BE49-F238E27FC236}">
                <a16:creationId xmlns:a16="http://schemas.microsoft.com/office/drawing/2014/main" id="{F5A02D59-C41E-46FD-A2B4-33A8646541D0}"/>
              </a:ext>
            </a:extLst>
          </p:cNvPr>
          <p:cNvSpPr txBox="1"/>
          <p:nvPr/>
        </p:nvSpPr>
        <p:spPr>
          <a:xfrm>
            <a:off x="3619001" y="4914682"/>
            <a:ext cx="1264934" cy="32489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igher concentration</a:t>
            </a:r>
          </a:p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in controls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ovéPole 1">
            <a:extLst>
              <a:ext uri="{FF2B5EF4-FFF2-40B4-BE49-F238E27FC236}">
                <a16:creationId xmlns:a16="http://schemas.microsoft.com/office/drawing/2014/main" id="{72210B23-52A7-45FE-9AD0-081F0AF168E9}"/>
              </a:ext>
            </a:extLst>
          </p:cNvPr>
          <p:cNvSpPr txBox="1"/>
          <p:nvPr/>
        </p:nvSpPr>
        <p:spPr>
          <a:xfrm>
            <a:off x="6045419" y="4922497"/>
            <a:ext cx="1264934" cy="32489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igher concentration </a:t>
            </a:r>
          </a:p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in HF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Obrázek 9">
            <a:extLst>
              <a:ext uri="{FF2B5EF4-FFF2-40B4-BE49-F238E27FC236}">
                <a16:creationId xmlns:a16="http://schemas.microsoft.com/office/drawing/2014/main" id="{48A796C7-E047-4C42-8B83-F83324D5D0EF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055" y="892571"/>
            <a:ext cx="3161715" cy="3678215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TextovéPole 10">
            <a:extLst>
              <a:ext uri="{FF2B5EF4-FFF2-40B4-BE49-F238E27FC236}">
                <a16:creationId xmlns:a16="http://schemas.microsoft.com/office/drawing/2014/main" id="{B1177325-B594-4DEB-9F12-A919EFBE49E1}"/>
              </a:ext>
            </a:extLst>
          </p:cNvPr>
          <p:cNvSpPr txBox="1"/>
          <p:nvPr/>
        </p:nvSpPr>
        <p:spPr>
          <a:xfrm>
            <a:off x="508000" y="3035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2" name="TextovéPole 11">
            <a:extLst>
              <a:ext uri="{FF2B5EF4-FFF2-40B4-BE49-F238E27FC236}">
                <a16:creationId xmlns:a16="http://schemas.microsoft.com/office/drawing/2014/main" id="{0B73BD73-346F-491C-BCCE-263404D5142B}"/>
              </a:ext>
            </a:extLst>
          </p:cNvPr>
          <p:cNvSpPr txBox="1"/>
          <p:nvPr/>
        </p:nvSpPr>
        <p:spPr>
          <a:xfrm>
            <a:off x="3619001" y="32870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13" name="Graf 12">
            <a:extLst>
              <a:ext uri="{FF2B5EF4-FFF2-40B4-BE49-F238E27FC236}">
                <a16:creationId xmlns:a16="http://schemas.microsoft.com/office/drawing/2014/main" id="{9A5F0206-F762-46DC-AC7F-82D8C869FFA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60216219"/>
              </p:ext>
            </p:extLst>
          </p:nvPr>
        </p:nvGraphicFramePr>
        <p:xfrm>
          <a:off x="8253045" y="727626"/>
          <a:ext cx="3548185" cy="4281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TextovéPole 1">
            <a:extLst>
              <a:ext uri="{FF2B5EF4-FFF2-40B4-BE49-F238E27FC236}">
                <a16:creationId xmlns:a16="http://schemas.microsoft.com/office/drawing/2014/main" id="{BDD102AA-E78E-4823-9682-77393B7FB438}"/>
              </a:ext>
            </a:extLst>
          </p:cNvPr>
          <p:cNvSpPr txBox="1"/>
          <p:nvPr/>
        </p:nvSpPr>
        <p:spPr>
          <a:xfrm>
            <a:off x="8368387" y="4964059"/>
            <a:ext cx="1113563" cy="335515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igher concentration in</a:t>
            </a:r>
          </a:p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F low PVR </a:t>
            </a:r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ovéPole 1">
            <a:extLst>
              <a:ext uri="{FF2B5EF4-FFF2-40B4-BE49-F238E27FC236}">
                <a16:creationId xmlns:a16="http://schemas.microsoft.com/office/drawing/2014/main" id="{059BA63B-5FF5-4B49-85C9-512BF81470E5}"/>
              </a:ext>
            </a:extLst>
          </p:cNvPr>
          <p:cNvSpPr txBox="1"/>
          <p:nvPr/>
        </p:nvSpPr>
        <p:spPr>
          <a:xfrm>
            <a:off x="10424642" y="4964059"/>
            <a:ext cx="1113598" cy="335515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igher concentration in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HF high PVR</a:t>
            </a:r>
          </a:p>
        </p:txBody>
      </p:sp>
      <p:sp>
        <p:nvSpPr>
          <p:cNvPr id="16" name="TextovéPole 15">
            <a:extLst>
              <a:ext uri="{FF2B5EF4-FFF2-40B4-BE49-F238E27FC236}">
                <a16:creationId xmlns:a16="http://schemas.microsoft.com/office/drawing/2014/main" id="{5CC464E4-DCFD-4A7A-B5F5-3898EC4BD53D}"/>
              </a:ext>
            </a:extLst>
          </p:cNvPr>
          <p:cNvSpPr txBox="1"/>
          <p:nvPr/>
        </p:nvSpPr>
        <p:spPr>
          <a:xfrm>
            <a:off x="8368387" y="34619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7" name="TextovéPole 16">
            <a:extLst>
              <a:ext uri="{FF2B5EF4-FFF2-40B4-BE49-F238E27FC236}">
                <a16:creationId xmlns:a16="http://schemas.microsoft.com/office/drawing/2014/main" id="{E3735230-8A5A-4375-9B1C-648D9E5DC77F}"/>
              </a:ext>
            </a:extLst>
          </p:cNvPr>
          <p:cNvSpPr txBox="1"/>
          <p:nvPr/>
        </p:nvSpPr>
        <p:spPr>
          <a:xfrm>
            <a:off x="146753" y="52078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2" name="TextovéPole 1">
            <a:extLst>
              <a:ext uri="{FF2B5EF4-FFF2-40B4-BE49-F238E27FC236}">
                <a16:creationId xmlns:a16="http://schemas.microsoft.com/office/drawing/2014/main" id="{5137426F-905E-4CC8-8753-17C69BA94F6E}"/>
              </a:ext>
            </a:extLst>
          </p:cNvPr>
          <p:cNvSpPr txBox="1"/>
          <p:nvPr/>
        </p:nvSpPr>
        <p:spPr>
          <a:xfrm>
            <a:off x="-6793" y="5790259"/>
            <a:ext cx="12205585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at map and hierarchical tree clustering of PA (mixed venous) concentrations of proteins in controls, HF patients with low PVR (Q1) and high PVR (Q4)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„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iomarkers“ of Heart Failu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ate identified by comparisons of proteins in PA (mixed venous blood) in controls (n=21) and in all HF subjects (n=80,Q1+Q4).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„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iomarkers“ of High pulmonary vascular resistanc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PVR) identified by comparing HF patients with low PVR (Q1, n=40) and high PVR (Q4. n=40). For abbreviations see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xt and Suppl. Table 1.</a:t>
            </a:r>
          </a:p>
        </p:txBody>
      </p:sp>
    </p:spTree>
    <p:extLst>
      <p:ext uri="{BB962C8B-B14F-4D97-AF65-F5344CB8AC3E}">
        <p14:creationId xmlns:p14="http://schemas.microsoft.com/office/powerpoint/2010/main" val="4456647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ázek 4">
            <a:extLst>
              <a:ext uri="{FF2B5EF4-FFF2-40B4-BE49-F238E27FC236}">
                <a16:creationId xmlns:a16="http://schemas.microsoft.com/office/drawing/2014/main" id="{9FE1E03D-3DFF-452E-8293-E4FB025FE73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2575" y="-65988"/>
            <a:ext cx="7840672" cy="6570386"/>
          </a:xfrm>
          <a:prstGeom prst="rect">
            <a:avLst/>
          </a:prstGeom>
        </p:spPr>
      </p:pic>
      <p:sp>
        <p:nvSpPr>
          <p:cNvPr id="6" name="TextovéPole 5">
            <a:extLst>
              <a:ext uri="{FF2B5EF4-FFF2-40B4-BE49-F238E27FC236}">
                <a16:creationId xmlns:a16="http://schemas.microsoft.com/office/drawing/2014/main" id="{917C5168-2E4A-4A3D-A5F5-7203ABE35F57}"/>
              </a:ext>
            </a:extLst>
          </p:cNvPr>
          <p:cNvSpPr txBox="1"/>
          <p:nvPr/>
        </p:nvSpPr>
        <p:spPr>
          <a:xfrm>
            <a:off x="267736" y="216978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ovéPole 3">
            <a:extLst>
              <a:ext uri="{FF2B5EF4-FFF2-40B4-BE49-F238E27FC236}">
                <a16:creationId xmlns:a16="http://schemas.microsoft.com/office/drawing/2014/main" id="{5137426F-905E-4CC8-8753-17C69BA94F6E}"/>
              </a:ext>
            </a:extLst>
          </p:cNvPr>
          <p:cNvSpPr txBox="1"/>
          <p:nvPr/>
        </p:nvSpPr>
        <p:spPr>
          <a:xfrm>
            <a:off x="285256" y="6227399"/>
            <a:ext cx="1100378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utative protein-protein interaction network for proteins differentially regulated (uptake 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l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cross pulmonary circulation in patients with</a:t>
            </a:r>
          </a:p>
          <a:p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ar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ailure and high pulmonary vascular resistance (STRING, v 12, https://string-db.org/). For abbreviations, see suppl table 1.</a:t>
            </a:r>
          </a:p>
        </p:txBody>
      </p:sp>
    </p:spTree>
    <p:extLst>
      <p:ext uri="{BB962C8B-B14F-4D97-AF65-F5344CB8AC3E}">
        <p14:creationId xmlns:p14="http://schemas.microsoft.com/office/powerpoint/2010/main" val="2207468651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Kancelář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celář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832</TotalTime>
  <Words>544</Words>
  <Application>Microsoft Office PowerPoint</Application>
  <PresentationFormat>Širokoúhlá obrazovka</PresentationFormat>
  <Paragraphs>62</Paragraphs>
  <Slides>4</Slides>
  <Notes>1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Motiv Office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Institut klinické a experimentální medicí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doc. MUDr. Vojtěch Melenovský, CSc.</dc:creator>
  <cp:lastModifiedBy>doc. MUDr. Vojtěch Melenovský, CSc.</cp:lastModifiedBy>
  <cp:revision>56</cp:revision>
  <cp:lastPrinted>2025-01-27T18:18:35Z</cp:lastPrinted>
  <dcterms:created xsi:type="dcterms:W3CDTF">2024-08-26T18:35:27Z</dcterms:created>
  <dcterms:modified xsi:type="dcterms:W3CDTF">2025-01-28T16:44:54Z</dcterms:modified>
</cp:coreProperties>
</file>